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  <p:sldId id="257" r:id="rId6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B1EF873-2902-46D0-9BC9-FAD3E957ECD0}" v="26" dt="2025-03-19T15:16:16.51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2429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ox, Elizabeth" userId="c7619ef2-11a7-4c4f-9237-3743934715e8" providerId="ADAL" clId="{9B1EF873-2902-46D0-9BC9-FAD3E957ECD0}"/>
    <pc:docChg chg="undo custSel addSld modSld">
      <pc:chgData name="Fox, Elizabeth" userId="c7619ef2-11a7-4c4f-9237-3743934715e8" providerId="ADAL" clId="{9B1EF873-2902-46D0-9BC9-FAD3E957ECD0}" dt="2025-03-19T15:35:43.619" v="1299" actId="1076"/>
      <pc:docMkLst>
        <pc:docMk/>
      </pc:docMkLst>
      <pc:sldChg chg="addSp delSp modSp mod">
        <pc:chgData name="Fox, Elizabeth" userId="c7619ef2-11a7-4c4f-9237-3743934715e8" providerId="ADAL" clId="{9B1EF873-2902-46D0-9BC9-FAD3E957ECD0}" dt="2025-03-19T15:35:43.619" v="1299" actId="1076"/>
        <pc:sldMkLst>
          <pc:docMk/>
          <pc:sldMk cId="3007879694" sldId="256"/>
        </pc:sldMkLst>
        <pc:spChg chg="mod">
          <ac:chgData name="Fox, Elizabeth" userId="c7619ef2-11a7-4c4f-9237-3743934715e8" providerId="ADAL" clId="{9B1EF873-2902-46D0-9BC9-FAD3E957ECD0}" dt="2025-03-19T12:00:29.002" v="538" actId="1038"/>
          <ac:spMkLst>
            <pc:docMk/>
            <pc:sldMk cId="3007879694" sldId="256"/>
            <ac:spMk id="4" creationId="{533AB7EE-28B5-6049-A803-3DEAC0E3BE85}"/>
          </ac:spMkLst>
        </pc:spChg>
        <pc:spChg chg="mod">
          <ac:chgData name="Fox, Elizabeth" userId="c7619ef2-11a7-4c4f-9237-3743934715e8" providerId="ADAL" clId="{9B1EF873-2902-46D0-9BC9-FAD3E957ECD0}" dt="2025-03-19T15:13:30.936" v="1247" actId="1076"/>
          <ac:spMkLst>
            <pc:docMk/>
            <pc:sldMk cId="3007879694" sldId="256"/>
            <ac:spMk id="5" creationId="{51699A68-24B1-5651-BAED-894E09C86007}"/>
          </ac:spMkLst>
        </pc:spChg>
        <pc:spChg chg="mod">
          <ac:chgData name="Fox, Elizabeth" userId="c7619ef2-11a7-4c4f-9237-3743934715e8" providerId="ADAL" clId="{9B1EF873-2902-46D0-9BC9-FAD3E957ECD0}" dt="2025-03-19T12:00:48.019" v="540" actId="1076"/>
          <ac:spMkLst>
            <pc:docMk/>
            <pc:sldMk cId="3007879694" sldId="256"/>
            <ac:spMk id="7" creationId="{9AC57011-5297-B432-85C9-3C50B8623F80}"/>
          </ac:spMkLst>
        </pc:spChg>
        <pc:spChg chg="mod">
          <ac:chgData name="Fox, Elizabeth" userId="c7619ef2-11a7-4c4f-9237-3743934715e8" providerId="ADAL" clId="{9B1EF873-2902-46D0-9BC9-FAD3E957ECD0}" dt="2025-03-19T12:00:29.002" v="538" actId="1038"/>
          <ac:spMkLst>
            <pc:docMk/>
            <pc:sldMk cId="3007879694" sldId="256"/>
            <ac:spMk id="8" creationId="{E072B163-C343-F479-11B3-20D7A967B200}"/>
          </ac:spMkLst>
        </pc:spChg>
        <pc:spChg chg="mod">
          <ac:chgData name="Fox, Elizabeth" userId="c7619ef2-11a7-4c4f-9237-3743934715e8" providerId="ADAL" clId="{9B1EF873-2902-46D0-9BC9-FAD3E957ECD0}" dt="2025-03-19T12:01:09.186" v="545" actId="1038"/>
          <ac:spMkLst>
            <pc:docMk/>
            <pc:sldMk cId="3007879694" sldId="256"/>
            <ac:spMk id="9" creationId="{6A5361CD-9341-0C29-4CAA-B89362DDF75A}"/>
          </ac:spMkLst>
        </pc:spChg>
        <pc:spChg chg="mod">
          <ac:chgData name="Fox, Elizabeth" userId="c7619ef2-11a7-4c4f-9237-3743934715e8" providerId="ADAL" clId="{9B1EF873-2902-46D0-9BC9-FAD3E957ECD0}" dt="2025-03-19T15:28:33.727" v="1286" actId="1076"/>
          <ac:spMkLst>
            <pc:docMk/>
            <pc:sldMk cId="3007879694" sldId="256"/>
            <ac:spMk id="10" creationId="{F0DAAD06-8276-40F6-A26E-DCD751AF63D7}"/>
          </ac:spMkLst>
        </pc:spChg>
        <pc:spChg chg="add mod">
          <ac:chgData name="Fox, Elizabeth" userId="c7619ef2-11a7-4c4f-9237-3743934715e8" providerId="ADAL" clId="{9B1EF873-2902-46D0-9BC9-FAD3E957ECD0}" dt="2025-03-19T11:58:14.449" v="507" actId="1038"/>
          <ac:spMkLst>
            <pc:docMk/>
            <pc:sldMk cId="3007879694" sldId="256"/>
            <ac:spMk id="12" creationId="{7033A3F5-E1D2-65D6-24A0-1C6363F02510}"/>
          </ac:spMkLst>
        </pc:spChg>
        <pc:spChg chg="mod">
          <ac:chgData name="Fox, Elizabeth" userId="c7619ef2-11a7-4c4f-9237-3743934715e8" providerId="ADAL" clId="{9B1EF873-2902-46D0-9BC9-FAD3E957ECD0}" dt="2025-03-19T14:11:24.798" v="815" actId="947"/>
          <ac:spMkLst>
            <pc:docMk/>
            <pc:sldMk cId="3007879694" sldId="256"/>
            <ac:spMk id="13" creationId="{D77E9862-BD50-433F-BC70-5A1A27A21E01}"/>
          </ac:spMkLst>
        </pc:spChg>
        <pc:spChg chg="add del mod">
          <ac:chgData name="Fox, Elizabeth" userId="c7619ef2-11a7-4c4f-9237-3743934715e8" providerId="ADAL" clId="{9B1EF873-2902-46D0-9BC9-FAD3E957ECD0}" dt="2025-03-18T19:50:57.303" v="307" actId="478"/>
          <ac:spMkLst>
            <pc:docMk/>
            <pc:sldMk cId="3007879694" sldId="256"/>
            <ac:spMk id="14" creationId="{58B6EA6C-EBE4-B5D6-6FA8-BB216132159D}"/>
          </ac:spMkLst>
        </pc:spChg>
        <pc:spChg chg="add mod">
          <ac:chgData name="Fox, Elizabeth" userId="c7619ef2-11a7-4c4f-9237-3743934715e8" providerId="ADAL" clId="{9B1EF873-2902-46D0-9BC9-FAD3E957ECD0}" dt="2025-03-19T15:04:22.429" v="1242" actId="1076"/>
          <ac:spMkLst>
            <pc:docMk/>
            <pc:sldMk cId="3007879694" sldId="256"/>
            <ac:spMk id="16" creationId="{245643FF-E6B6-3D05-E15F-0CCF89E92FB5}"/>
          </ac:spMkLst>
        </pc:spChg>
        <pc:spChg chg="del">
          <ac:chgData name="Fox, Elizabeth" userId="c7619ef2-11a7-4c4f-9237-3743934715e8" providerId="ADAL" clId="{9B1EF873-2902-46D0-9BC9-FAD3E957ECD0}" dt="2025-03-18T19:52:28.096" v="321" actId="478"/>
          <ac:spMkLst>
            <pc:docMk/>
            <pc:sldMk cId="3007879694" sldId="256"/>
            <ac:spMk id="16" creationId="{349DDB1D-41D3-4CF1-85CE-CC0ED200B018}"/>
          </ac:spMkLst>
        </pc:spChg>
        <pc:spChg chg="del">
          <ac:chgData name="Fox, Elizabeth" userId="c7619ef2-11a7-4c4f-9237-3743934715e8" providerId="ADAL" clId="{9B1EF873-2902-46D0-9BC9-FAD3E957ECD0}" dt="2025-03-18T19:50:18.413" v="299" actId="478"/>
          <ac:spMkLst>
            <pc:docMk/>
            <pc:sldMk cId="3007879694" sldId="256"/>
            <ac:spMk id="17" creationId="{5DAC98D3-325F-4FBA-BDB5-21A30CE494DA}"/>
          </ac:spMkLst>
        </pc:spChg>
        <pc:spChg chg="add mod">
          <ac:chgData name="Fox, Elizabeth" userId="c7619ef2-11a7-4c4f-9237-3743934715e8" providerId="ADAL" clId="{9B1EF873-2902-46D0-9BC9-FAD3E957ECD0}" dt="2025-03-18T19:53:42.891" v="328" actId="571"/>
          <ac:spMkLst>
            <pc:docMk/>
            <pc:sldMk cId="3007879694" sldId="256"/>
            <ac:spMk id="22" creationId="{0A7D38AC-C469-7282-E502-58FBDC1E2846}"/>
          </ac:spMkLst>
        </pc:spChg>
        <pc:spChg chg="mod">
          <ac:chgData name="Fox, Elizabeth" userId="c7619ef2-11a7-4c4f-9237-3743934715e8" providerId="ADAL" clId="{9B1EF873-2902-46D0-9BC9-FAD3E957ECD0}" dt="2025-03-19T15:02:15.214" v="1239" actId="14100"/>
          <ac:spMkLst>
            <pc:docMk/>
            <pc:sldMk cId="3007879694" sldId="256"/>
            <ac:spMk id="23" creationId="{F00342B0-F987-FC6A-29DE-6F881E6B1623}"/>
          </ac:spMkLst>
        </pc:spChg>
        <pc:spChg chg="add mod">
          <ac:chgData name="Fox, Elizabeth" userId="c7619ef2-11a7-4c4f-9237-3743934715e8" providerId="ADAL" clId="{9B1EF873-2902-46D0-9BC9-FAD3E957ECD0}" dt="2025-03-18T19:53:42.891" v="328" actId="571"/>
          <ac:spMkLst>
            <pc:docMk/>
            <pc:sldMk cId="3007879694" sldId="256"/>
            <ac:spMk id="24" creationId="{0838DBBF-010F-36AF-E728-CD4B52B0DCDA}"/>
          </ac:spMkLst>
        </pc:spChg>
        <pc:spChg chg="mod">
          <ac:chgData name="Fox, Elizabeth" userId="c7619ef2-11a7-4c4f-9237-3743934715e8" providerId="ADAL" clId="{9B1EF873-2902-46D0-9BC9-FAD3E957ECD0}" dt="2025-03-19T15:04:18.014" v="1241" actId="1076"/>
          <ac:spMkLst>
            <pc:docMk/>
            <pc:sldMk cId="3007879694" sldId="256"/>
            <ac:spMk id="25" creationId="{7CD389C0-F022-4EB4-A21D-D21FD76EEC25}"/>
          </ac:spMkLst>
        </pc:spChg>
        <pc:spChg chg="del mod">
          <ac:chgData name="Fox, Elizabeth" userId="c7619ef2-11a7-4c4f-9237-3743934715e8" providerId="ADAL" clId="{9B1EF873-2902-46D0-9BC9-FAD3E957ECD0}" dt="2025-03-18T19:55:14.949" v="337" actId="478"/>
          <ac:spMkLst>
            <pc:docMk/>
            <pc:sldMk cId="3007879694" sldId="256"/>
            <ac:spMk id="26" creationId="{131C2486-AF18-4779-BE07-CEEAB52D8CCD}"/>
          </ac:spMkLst>
        </pc:spChg>
        <pc:spChg chg="mod">
          <ac:chgData name="Fox, Elizabeth" userId="c7619ef2-11a7-4c4f-9237-3743934715e8" providerId="ADAL" clId="{9B1EF873-2902-46D0-9BC9-FAD3E957ECD0}" dt="2025-03-19T11:59:17.734" v="509" actId="1076"/>
          <ac:spMkLst>
            <pc:docMk/>
            <pc:sldMk cId="3007879694" sldId="256"/>
            <ac:spMk id="27" creationId="{05FF95FA-99E2-4686-BED5-3ED60C0A5193}"/>
          </ac:spMkLst>
        </pc:spChg>
        <pc:spChg chg="mod">
          <ac:chgData name="Fox, Elizabeth" userId="c7619ef2-11a7-4c4f-9237-3743934715e8" providerId="ADAL" clId="{9B1EF873-2902-46D0-9BC9-FAD3E957ECD0}" dt="2025-03-19T14:18:18.142" v="825" actId="947"/>
          <ac:spMkLst>
            <pc:docMk/>
            <pc:sldMk cId="3007879694" sldId="256"/>
            <ac:spMk id="28" creationId="{77CFF669-0751-45C8-9079-C0DA62F0D433}"/>
          </ac:spMkLst>
        </pc:spChg>
        <pc:spChg chg="mod">
          <ac:chgData name="Fox, Elizabeth" userId="c7619ef2-11a7-4c4f-9237-3743934715e8" providerId="ADAL" clId="{9B1EF873-2902-46D0-9BC9-FAD3E957ECD0}" dt="2025-03-19T14:01:17.484" v="720" actId="1035"/>
          <ac:spMkLst>
            <pc:docMk/>
            <pc:sldMk cId="3007879694" sldId="256"/>
            <ac:spMk id="29" creationId="{F73C9F69-2379-492B-9C79-1ACA3D7A8465}"/>
          </ac:spMkLst>
        </pc:spChg>
        <pc:spChg chg="mod">
          <ac:chgData name="Fox, Elizabeth" userId="c7619ef2-11a7-4c4f-9237-3743934715e8" providerId="ADAL" clId="{9B1EF873-2902-46D0-9BC9-FAD3E957ECD0}" dt="2025-03-19T15:27:06.428" v="1283" actId="1076"/>
          <ac:spMkLst>
            <pc:docMk/>
            <pc:sldMk cId="3007879694" sldId="256"/>
            <ac:spMk id="30" creationId="{BF2A4347-05ED-4596-AB59-FDA7AE84A45E}"/>
          </ac:spMkLst>
        </pc:spChg>
        <pc:spChg chg="add mod">
          <ac:chgData name="Fox, Elizabeth" userId="c7619ef2-11a7-4c4f-9237-3743934715e8" providerId="ADAL" clId="{9B1EF873-2902-46D0-9BC9-FAD3E957ECD0}" dt="2025-03-18T19:53:42.891" v="328" actId="571"/>
          <ac:spMkLst>
            <pc:docMk/>
            <pc:sldMk cId="3007879694" sldId="256"/>
            <ac:spMk id="31" creationId="{E34ACDBC-515C-FA88-EC31-C435B0B979E9}"/>
          </ac:spMkLst>
        </pc:spChg>
        <pc:spChg chg="mod">
          <ac:chgData name="Fox, Elizabeth" userId="c7619ef2-11a7-4c4f-9237-3743934715e8" providerId="ADAL" clId="{9B1EF873-2902-46D0-9BC9-FAD3E957ECD0}" dt="2025-03-19T14:43:00.802" v="1168" actId="1035"/>
          <ac:spMkLst>
            <pc:docMk/>
            <pc:sldMk cId="3007879694" sldId="256"/>
            <ac:spMk id="33" creationId="{9BF96916-7180-4FC6-9122-60E62D54B8AF}"/>
          </ac:spMkLst>
        </pc:spChg>
        <pc:spChg chg="add mod">
          <ac:chgData name="Fox, Elizabeth" userId="c7619ef2-11a7-4c4f-9237-3743934715e8" providerId="ADAL" clId="{9B1EF873-2902-46D0-9BC9-FAD3E957ECD0}" dt="2025-03-18T19:53:42.891" v="328" actId="571"/>
          <ac:spMkLst>
            <pc:docMk/>
            <pc:sldMk cId="3007879694" sldId="256"/>
            <ac:spMk id="35" creationId="{5A53964D-1496-B1D7-E8CF-A052FF0F8B4E}"/>
          </ac:spMkLst>
        </pc:spChg>
        <pc:spChg chg="del mod">
          <ac:chgData name="Fox, Elizabeth" userId="c7619ef2-11a7-4c4f-9237-3743934715e8" providerId="ADAL" clId="{9B1EF873-2902-46D0-9BC9-FAD3E957ECD0}" dt="2025-03-19T14:05:23.307" v="752" actId="478"/>
          <ac:spMkLst>
            <pc:docMk/>
            <pc:sldMk cId="3007879694" sldId="256"/>
            <ac:spMk id="37" creationId="{DBB97BB8-A6E7-49AF-8574-8E91C3A9C874}"/>
          </ac:spMkLst>
        </pc:spChg>
        <pc:spChg chg="mod">
          <ac:chgData name="Fox, Elizabeth" userId="c7619ef2-11a7-4c4f-9237-3743934715e8" providerId="ADAL" clId="{9B1EF873-2902-46D0-9BC9-FAD3E957ECD0}" dt="2025-03-19T15:29:39.215" v="1295" actId="1076"/>
          <ac:spMkLst>
            <pc:docMk/>
            <pc:sldMk cId="3007879694" sldId="256"/>
            <ac:spMk id="38" creationId="{1545E607-9759-4D15-BD41-F54C6F126183}"/>
          </ac:spMkLst>
        </pc:spChg>
        <pc:spChg chg="add mod">
          <ac:chgData name="Fox, Elizabeth" userId="c7619ef2-11a7-4c4f-9237-3743934715e8" providerId="ADAL" clId="{9B1EF873-2902-46D0-9BC9-FAD3E957ECD0}" dt="2025-03-18T19:53:42.891" v="328" actId="571"/>
          <ac:spMkLst>
            <pc:docMk/>
            <pc:sldMk cId="3007879694" sldId="256"/>
            <ac:spMk id="40" creationId="{4E1ED1F4-1036-28FC-2711-612FD964A584}"/>
          </ac:spMkLst>
        </pc:spChg>
        <pc:spChg chg="add mod">
          <ac:chgData name="Fox, Elizabeth" userId="c7619ef2-11a7-4c4f-9237-3743934715e8" providerId="ADAL" clId="{9B1EF873-2902-46D0-9BC9-FAD3E957ECD0}" dt="2025-03-19T15:19:27.478" v="1273" actId="108"/>
          <ac:spMkLst>
            <pc:docMk/>
            <pc:sldMk cId="3007879694" sldId="256"/>
            <ac:spMk id="51" creationId="{097F897A-D76B-C43F-D304-7BC411850C6B}"/>
          </ac:spMkLst>
        </pc:spChg>
        <pc:spChg chg="add mod">
          <ac:chgData name="Fox, Elizabeth" userId="c7619ef2-11a7-4c4f-9237-3743934715e8" providerId="ADAL" clId="{9B1EF873-2902-46D0-9BC9-FAD3E957ECD0}" dt="2025-03-19T14:43:00.802" v="1168" actId="1035"/>
          <ac:spMkLst>
            <pc:docMk/>
            <pc:sldMk cId="3007879694" sldId="256"/>
            <ac:spMk id="58" creationId="{FE4FAB31-4744-C8C4-E6B2-5E60828C5FAE}"/>
          </ac:spMkLst>
        </pc:spChg>
        <pc:spChg chg="add mod">
          <ac:chgData name="Fox, Elizabeth" userId="c7619ef2-11a7-4c4f-9237-3743934715e8" providerId="ADAL" clId="{9B1EF873-2902-46D0-9BC9-FAD3E957ECD0}" dt="2025-03-19T14:26:08.954" v="1066" actId="1076"/>
          <ac:spMkLst>
            <pc:docMk/>
            <pc:sldMk cId="3007879694" sldId="256"/>
            <ac:spMk id="80" creationId="{2ED590A2-8937-AC22-AC61-ECCBEDF4F2A6}"/>
          </ac:spMkLst>
        </pc:spChg>
        <pc:spChg chg="add mod">
          <ac:chgData name="Fox, Elizabeth" userId="c7619ef2-11a7-4c4f-9237-3743934715e8" providerId="ADAL" clId="{9B1EF873-2902-46D0-9BC9-FAD3E957ECD0}" dt="2025-03-19T14:29:55.878" v="1094" actId="20577"/>
          <ac:spMkLst>
            <pc:docMk/>
            <pc:sldMk cId="3007879694" sldId="256"/>
            <ac:spMk id="83" creationId="{B01FEE59-12A7-D12F-3CC0-CC00026C29E5}"/>
          </ac:spMkLst>
        </pc:spChg>
        <pc:spChg chg="del">
          <ac:chgData name="Fox, Elizabeth" userId="c7619ef2-11a7-4c4f-9237-3743934715e8" providerId="ADAL" clId="{9B1EF873-2902-46D0-9BC9-FAD3E957ECD0}" dt="2025-03-19T11:57:59.499" v="477" actId="478"/>
          <ac:spMkLst>
            <pc:docMk/>
            <pc:sldMk cId="3007879694" sldId="256"/>
            <ac:spMk id="84" creationId="{563AAB04-8909-4260-8FE0-76856FC3242C}"/>
          </ac:spMkLst>
        </pc:spChg>
        <pc:spChg chg="add mod">
          <ac:chgData name="Fox, Elizabeth" userId="c7619ef2-11a7-4c4f-9237-3743934715e8" providerId="ADAL" clId="{9B1EF873-2902-46D0-9BC9-FAD3E957ECD0}" dt="2025-03-19T14:29:46.623" v="1081" actId="20577"/>
          <ac:spMkLst>
            <pc:docMk/>
            <pc:sldMk cId="3007879694" sldId="256"/>
            <ac:spMk id="87" creationId="{1AEDA3E7-A07C-F231-1CE2-411B82882A05}"/>
          </ac:spMkLst>
        </pc:spChg>
        <pc:spChg chg="add del mod">
          <ac:chgData name="Fox, Elizabeth" userId="c7619ef2-11a7-4c4f-9237-3743934715e8" providerId="ADAL" clId="{9B1EF873-2902-46D0-9BC9-FAD3E957ECD0}" dt="2025-03-19T14:46:46.097" v="1209" actId="478"/>
          <ac:spMkLst>
            <pc:docMk/>
            <pc:sldMk cId="3007879694" sldId="256"/>
            <ac:spMk id="88" creationId="{4944FDE5-D9CD-81FC-B6A0-94335B574237}"/>
          </ac:spMkLst>
        </pc:spChg>
        <pc:spChg chg="add mod">
          <ac:chgData name="Fox, Elizabeth" userId="c7619ef2-11a7-4c4f-9237-3743934715e8" providerId="ADAL" clId="{9B1EF873-2902-46D0-9BC9-FAD3E957ECD0}" dt="2025-03-19T15:27:50.546" v="1285" actId="1076"/>
          <ac:spMkLst>
            <pc:docMk/>
            <pc:sldMk cId="3007879694" sldId="256"/>
            <ac:spMk id="89" creationId="{5171C296-F31E-1D94-3D0C-2D9AD60FCBDE}"/>
          </ac:spMkLst>
        </pc:spChg>
        <pc:spChg chg="add mod">
          <ac:chgData name="Fox, Elizabeth" userId="c7619ef2-11a7-4c4f-9237-3743934715e8" providerId="ADAL" clId="{9B1EF873-2902-46D0-9BC9-FAD3E957ECD0}" dt="2025-03-19T15:35:43.619" v="1299" actId="1076"/>
          <ac:spMkLst>
            <pc:docMk/>
            <pc:sldMk cId="3007879694" sldId="256"/>
            <ac:spMk id="101" creationId="{CA4356AE-0F84-DBC3-1A89-90BF77E298FA}"/>
          </ac:spMkLst>
        </pc:spChg>
        <pc:spChg chg="del mod">
          <ac:chgData name="Fox, Elizabeth" userId="c7619ef2-11a7-4c4f-9237-3743934715e8" providerId="ADAL" clId="{9B1EF873-2902-46D0-9BC9-FAD3E957ECD0}" dt="2025-03-19T11:58:01.532" v="479" actId="478"/>
          <ac:spMkLst>
            <pc:docMk/>
            <pc:sldMk cId="3007879694" sldId="256"/>
            <ac:spMk id="118" creationId="{6D7C3738-F73E-44D7-B4E4-35858D3A48C7}"/>
          </ac:spMkLst>
        </pc:spChg>
        <pc:spChg chg="del mod">
          <ac:chgData name="Fox, Elizabeth" userId="c7619ef2-11a7-4c4f-9237-3743934715e8" providerId="ADAL" clId="{9B1EF873-2902-46D0-9BC9-FAD3E957ECD0}" dt="2025-03-18T19:54:03.452" v="330" actId="478"/>
          <ac:spMkLst>
            <pc:docMk/>
            <pc:sldMk cId="3007879694" sldId="256"/>
            <ac:spMk id="122" creationId="{C9336000-355A-4061-94FF-F10AEB1D2D85}"/>
          </ac:spMkLst>
        </pc:spChg>
        <pc:spChg chg="mod">
          <ac:chgData name="Fox, Elizabeth" userId="c7619ef2-11a7-4c4f-9237-3743934715e8" providerId="ADAL" clId="{9B1EF873-2902-46D0-9BC9-FAD3E957ECD0}" dt="2025-03-19T14:01:17.484" v="720" actId="1035"/>
          <ac:spMkLst>
            <pc:docMk/>
            <pc:sldMk cId="3007879694" sldId="256"/>
            <ac:spMk id="124" creationId="{674448F4-E74C-4EC3-9527-12197CF0E881}"/>
          </ac:spMkLst>
        </pc:spChg>
        <pc:spChg chg="mod">
          <ac:chgData name="Fox, Elizabeth" userId="c7619ef2-11a7-4c4f-9237-3743934715e8" providerId="ADAL" clId="{9B1EF873-2902-46D0-9BC9-FAD3E957ECD0}" dt="2025-03-19T14:01:17.484" v="720" actId="1035"/>
          <ac:spMkLst>
            <pc:docMk/>
            <pc:sldMk cId="3007879694" sldId="256"/>
            <ac:spMk id="128" creationId="{D30DFE23-69C3-47EE-AF80-7E5A8DC45E20}"/>
          </ac:spMkLst>
        </pc:spChg>
        <pc:spChg chg="mod">
          <ac:chgData name="Fox, Elizabeth" userId="c7619ef2-11a7-4c4f-9237-3743934715e8" providerId="ADAL" clId="{9B1EF873-2902-46D0-9BC9-FAD3E957ECD0}" dt="2025-03-19T15:29:33.058" v="1293" actId="1076"/>
          <ac:spMkLst>
            <pc:docMk/>
            <pc:sldMk cId="3007879694" sldId="256"/>
            <ac:spMk id="133" creationId="{4D00D8A1-3B0C-41F3-A00D-E6227C0EEFD6}"/>
          </ac:spMkLst>
        </pc:spChg>
        <pc:spChg chg="mod">
          <ac:chgData name="Fox, Elizabeth" userId="c7619ef2-11a7-4c4f-9237-3743934715e8" providerId="ADAL" clId="{9B1EF873-2902-46D0-9BC9-FAD3E957ECD0}" dt="2025-03-19T15:35:23.878" v="1298" actId="20577"/>
          <ac:spMkLst>
            <pc:docMk/>
            <pc:sldMk cId="3007879694" sldId="256"/>
            <ac:spMk id="134" creationId="{F1C6DF61-B485-4BD3-9F7A-2A75BA971966}"/>
          </ac:spMkLst>
        </pc:spChg>
        <pc:spChg chg="mod">
          <ac:chgData name="Fox, Elizabeth" userId="c7619ef2-11a7-4c4f-9237-3743934715e8" providerId="ADAL" clId="{9B1EF873-2902-46D0-9BC9-FAD3E957ECD0}" dt="2025-03-19T14:43:00.802" v="1168" actId="1035"/>
          <ac:spMkLst>
            <pc:docMk/>
            <pc:sldMk cId="3007879694" sldId="256"/>
            <ac:spMk id="137" creationId="{1E10791E-0645-7A8D-3CD0-A66775CB4CDE}"/>
          </ac:spMkLst>
        </pc:spChg>
        <pc:spChg chg="mod">
          <ac:chgData name="Fox, Elizabeth" userId="c7619ef2-11a7-4c4f-9237-3743934715e8" providerId="ADAL" clId="{9B1EF873-2902-46D0-9BC9-FAD3E957ECD0}" dt="2025-03-19T14:43:13.368" v="1169" actId="1076"/>
          <ac:spMkLst>
            <pc:docMk/>
            <pc:sldMk cId="3007879694" sldId="256"/>
            <ac:spMk id="163" creationId="{F519353C-ACB2-009D-71DD-DA957017DA1D}"/>
          </ac:spMkLst>
        </pc:spChg>
        <pc:spChg chg="mod">
          <ac:chgData name="Fox, Elizabeth" userId="c7619ef2-11a7-4c4f-9237-3743934715e8" providerId="ADAL" clId="{9B1EF873-2902-46D0-9BC9-FAD3E957ECD0}" dt="2025-03-19T15:16:23.517" v="1267" actId="14100"/>
          <ac:spMkLst>
            <pc:docMk/>
            <pc:sldMk cId="3007879694" sldId="256"/>
            <ac:spMk id="164" creationId="{5CC554D3-F1A4-B9F5-270F-5E1BFC66F060}"/>
          </ac:spMkLst>
        </pc:spChg>
        <pc:spChg chg="mod">
          <ac:chgData name="Fox, Elizabeth" userId="c7619ef2-11a7-4c4f-9237-3743934715e8" providerId="ADAL" clId="{9B1EF873-2902-46D0-9BC9-FAD3E957ECD0}" dt="2025-03-19T14:24:03.826" v="1049" actId="1076"/>
          <ac:spMkLst>
            <pc:docMk/>
            <pc:sldMk cId="3007879694" sldId="256"/>
            <ac:spMk id="167" creationId="{877705AE-1A4C-4EC4-EC05-BB62135314F2}"/>
          </ac:spMkLst>
        </pc:spChg>
        <pc:spChg chg="mod">
          <ac:chgData name="Fox, Elizabeth" userId="c7619ef2-11a7-4c4f-9237-3743934715e8" providerId="ADAL" clId="{9B1EF873-2902-46D0-9BC9-FAD3E957ECD0}" dt="2025-03-19T15:13:10.439" v="1244" actId="14100"/>
          <ac:spMkLst>
            <pc:docMk/>
            <pc:sldMk cId="3007879694" sldId="256"/>
            <ac:spMk id="169" creationId="{A89AB435-1ECE-C589-CE4B-8C89BDDC4852}"/>
          </ac:spMkLst>
        </pc:spChg>
        <pc:cxnChg chg="add mod">
          <ac:chgData name="Fox, Elizabeth" userId="c7619ef2-11a7-4c4f-9237-3743934715e8" providerId="ADAL" clId="{9B1EF873-2902-46D0-9BC9-FAD3E957ECD0}" dt="2025-03-19T15:04:27.290" v="1243" actId="1076"/>
          <ac:cxnSpMkLst>
            <pc:docMk/>
            <pc:sldMk cId="3007879694" sldId="256"/>
            <ac:cxnSpMk id="17" creationId="{52723BD1-CE4A-FC2B-CD74-1C46217E1DE6}"/>
          </ac:cxnSpMkLst>
        </pc:cxnChg>
        <pc:cxnChg chg="add mod">
          <ac:chgData name="Fox, Elizabeth" userId="c7619ef2-11a7-4c4f-9237-3743934715e8" providerId="ADAL" clId="{9B1EF873-2902-46D0-9BC9-FAD3E957ECD0}" dt="2025-03-19T11:58:14.449" v="507" actId="1038"/>
          <ac:cxnSpMkLst>
            <pc:docMk/>
            <pc:sldMk cId="3007879694" sldId="256"/>
            <ac:cxnSpMk id="18" creationId="{66C2FD67-C55C-C5F0-694A-73F3AFCAF003}"/>
          </ac:cxnSpMkLst>
        </pc:cxnChg>
        <pc:cxnChg chg="add mod">
          <ac:chgData name="Fox, Elizabeth" userId="c7619ef2-11a7-4c4f-9237-3743934715e8" providerId="ADAL" clId="{9B1EF873-2902-46D0-9BC9-FAD3E957ECD0}" dt="2025-03-19T15:26:13.208" v="1279" actId="1076"/>
          <ac:cxnSpMkLst>
            <pc:docMk/>
            <pc:sldMk cId="3007879694" sldId="256"/>
            <ac:cxnSpMk id="19" creationId="{9D454FDF-E4F8-1535-A147-C779E493F2B5}"/>
          </ac:cxnSpMkLst>
        </pc:cxnChg>
        <pc:cxnChg chg="del mod">
          <ac:chgData name="Fox, Elizabeth" userId="c7619ef2-11a7-4c4f-9237-3743934715e8" providerId="ADAL" clId="{9B1EF873-2902-46D0-9BC9-FAD3E957ECD0}" dt="2025-03-18T19:52:09.805" v="320" actId="478"/>
          <ac:cxnSpMkLst>
            <pc:docMk/>
            <pc:sldMk cId="3007879694" sldId="256"/>
            <ac:cxnSpMk id="21" creationId="{BE56C444-CBBB-197E-FFE4-566E9AF3977D}"/>
          </ac:cxnSpMkLst>
        </pc:cxnChg>
        <pc:cxnChg chg="del mod">
          <ac:chgData name="Fox, Elizabeth" userId="c7619ef2-11a7-4c4f-9237-3743934715e8" providerId="ADAL" clId="{9B1EF873-2902-46D0-9BC9-FAD3E957ECD0}" dt="2025-03-19T14:11:03.954" v="812" actId="478"/>
          <ac:cxnSpMkLst>
            <pc:docMk/>
            <pc:sldMk cId="3007879694" sldId="256"/>
            <ac:cxnSpMk id="32" creationId="{0A2E38FC-8F3D-D06A-3ADE-CEAEAFC8F515}"/>
          </ac:cxnSpMkLst>
        </pc:cxnChg>
        <pc:cxnChg chg="add mod">
          <ac:chgData name="Fox, Elizabeth" userId="c7619ef2-11a7-4c4f-9237-3743934715e8" providerId="ADAL" clId="{9B1EF873-2902-46D0-9BC9-FAD3E957ECD0}" dt="2025-03-18T19:53:42.891" v="328" actId="571"/>
          <ac:cxnSpMkLst>
            <pc:docMk/>
            <pc:sldMk cId="3007879694" sldId="256"/>
            <ac:cxnSpMk id="34" creationId="{70F3B5A9-338C-7D57-ED1A-F57826461022}"/>
          </ac:cxnSpMkLst>
        </pc:cxnChg>
        <pc:cxnChg chg="add mod">
          <ac:chgData name="Fox, Elizabeth" userId="c7619ef2-11a7-4c4f-9237-3743934715e8" providerId="ADAL" clId="{9B1EF873-2902-46D0-9BC9-FAD3E957ECD0}" dt="2025-03-18T19:53:42.891" v="328" actId="571"/>
          <ac:cxnSpMkLst>
            <pc:docMk/>
            <pc:sldMk cId="3007879694" sldId="256"/>
            <ac:cxnSpMk id="36" creationId="{B10B1703-59BA-8C3A-4A19-772E7B7A601A}"/>
          </ac:cxnSpMkLst>
        </pc:cxnChg>
        <pc:cxnChg chg="add mod">
          <ac:chgData name="Fox, Elizabeth" userId="c7619ef2-11a7-4c4f-9237-3743934715e8" providerId="ADAL" clId="{9B1EF873-2902-46D0-9BC9-FAD3E957ECD0}" dt="2025-03-19T14:43:00.802" v="1168" actId="1035"/>
          <ac:cxnSpMkLst>
            <pc:docMk/>
            <pc:sldMk cId="3007879694" sldId="256"/>
            <ac:cxnSpMk id="39" creationId="{7F90B88D-754A-0BF3-3270-B93EA899110F}"/>
          </ac:cxnSpMkLst>
        </pc:cxnChg>
        <pc:cxnChg chg="add mod">
          <ac:chgData name="Fox, Elizabeth" userId="c7619ef2-11a7-4c4f-9237-3743934715e8" providerId="ADAL" clId="{9B1EF873-2902-46D0-9BC9-FAD3E957ECD0}" dt="2025-03-18T19:53:42.891" v="328" actId="571"/>
          <ac:cxnSpMkLst>
            <pc:docMk/>
            <pc:sldMk cId="3007879694" sldId="256"/>
            <ac:cxnSpMk id="39" creationId="{DA6C85A1-2DBC-04CA-9D18-5F2978FC3349}"/>
          </ac:cxnSpMkLst>
        </pc:cxnChg>
        <pc:cxnChg chg="mod">
          <ac:chgData name="Fox, Elizabeth" userId="c7619ef2-11a7-4c4f-9237-3743934715e8" providerId="ADAL" clId="{9B1EF873-2902-46D0-9BC9-FAD3E957ECD0}" dt="2025-03-19T15:29:35.474" v="1294" actId="14100"/>
          <ac:cxnSpMkLst>
            <pc:docMk/>
            <pc:sldMk cId="3007879694" sldId="256"/>
            <ac:cxnSpMk id="41" creationId="{CF0D5C5C-57E4-4352-9D4D-087BCAE623FD}"/>
          </ac:cxnSpMkLst>
        </pc:cxnChg>
        <pc:cxnChg chg="mod">
          <ac:chgData name="Fox, Elizabeth" userId="c7619ef2-11a7-4c4f-9237-3743934715e8" providerId="ADAL" clId="{9B1EF873-2902-46D0-9BC9-FAD3E957ECD0}" dt="2025-03-19T12:00:36.458" v="539" actId="14100"/>
          <ac:cxnSpMkLst>
            <pc:docMk/>
            <pc:sldMk cId="3007879694" sldId="256"/>
            <ac:cxnSpMk id="46" creationId="{8BB99208-8573-A7BA-A354-9E8CC7E6766F}"/>
          </ac:cxnSpMkLst>
        </pc:cxnChg>
        <pc:cxnChg chg="mod">
          <ac:chgData name="Fox, Elizabeth" userId="c7619ef2-11a7-4c4f-9237-3743934715e8" providerId="ADAL" clId="{9B1EF873-2902-46D0-9BC9-FAD3E957ECD0}" dt="2025-03-19T15:28:48.486" v="1289" actId="1037"/>
          <ac:cxnSpMkLst>
            <pc:docMk/>
            <pc:sldMk cId="3007879694" sldId="256"/>
            <ac:cxnSpMk id="48" creationId="{EEE0D6D5-77B7-4AE6-AAE7-E9B70B383443}"/>
          </ac:cxnSpMkLst>
        </pc:cxnChg>
        <pc:cxnChg chg="del mod">
          <ac:chgData name="Fox, Elizabeth" userId="c7619ef2-11a7-4c4f-9237-3743934715e8" providerId="ADAL" clId="{9B1EF873-2902-46D0-9BC9-FAD3E957ECD0}" dt="2025-03-18T19:52:30.715" v="322" actId="478"/>
          <ac:cxnSpMkLst>
            <pc:docMk/>
            <pc:sldMk cId="3007879694" sldId="256"/>
            <ac:cxnSpMk id="50" creationId="{975D471F-E5D6-4159-A51A-BCC219CA6988}"/>
          </ac:cxnSpMkLst>
        </pc:cxnChg>
        <pc:cxnChg chg="mod">
          <ac:chgData name="Fox, Elizabeth" userId="c7619ef2-11a7-4c4f-9237-3743934715e8" providerId="ADAL" clId="{9B1EF873-2902-46D0-9BC9-FAD3E957ECD0}" dt="2025-03-19T12:00:15.485" v="525" actId="14100"/>
          <ac:cxnSpMkLst>
            <pc:docMk/>
            <pc:sldMk cId="3007879694" sldId="256"/>
            <ac:cxnSpMk id="52" creationId="{6917EB4A-BB93-A338-8DC1-B2A54D33D073}"/>
          </ac:cxnSpMkLst>
        </pc:cxnChg>
        <pc:cxnChg chg="mod">
          <ac:chgData name="Fox, Elizabeth" userId="c7619ef2-11a7-4c4f-9237-3743934715e8" providerId="ADAL" clId="{9B1EF873-2902-46D0-9BC9-FAD3E957ECD0}" dt="2025-03-19T14:25:56.494" v="1065" actId="14100"/>
          <ac:cxnSpMkLst>
            <pc:docMk/>
            <pc:sldMk cId="3007879694" sldId="256"/>
            <ac:cxnSpMk id="54" creationId="{644148E5-C0E5-AACF-D0B8-9417FE1912D8}"/>
          </ac:cxnSpMkLst>
        </pc:cxnChg>
        <pc:cxnChg chg="mod">
          <ac:chgData name="Fox, Elizabeth" userId="c7619ef2-11a7-4c4f-9237-3743934715e8" providerId="ADAL" clId="{9B1EF873-2902-46D0-9BC9-FAD3E957ECD0}" dt="2025-03-19T11:58:24.933" v="508" actId="14100"/>
          <ac:cxnSpMkLst>
            <pc:docMk/>
            <pc:sldMk cId="3007879694" sldId="256"/>
            <ac:cxnSpMk id="57" creationId="{E18B6460-DB1A-414A-A484-632141826535}"/>
          </ac:cxnSpMkLst>
        </pc:cxnChg>
        <pc:cxnChg chg="mod">
          <ac:chgData name="Fox, Elizabeth" userId="c7619ef2-11a7-4c4f-9237-3743934715e8" providerId="ADAL" clId="{9B1EF873-2902-46D0-9BC9-FAD3E957ECD0}" dt="2025-03-19T14:01:17.484" v="720" actId="1035"/>
          <ac:cxnSpMkLst>
            <pc:docMk/>
            <pc:sldMk cId="3007879694" sldId="256"/>
            <ac:cxnSpMk id="59" creationId="{0CB0B4DD-8EB5-4009-9B9E-22343EC5C0C3}"/>
          </ac:cxnSpMkLst>
        </pc:cxnChg>
        <pc:cxnChg chg="add mod">
          <ac:chgData name="Fox, Elizabeth" userId="c7619ef2-11a7-4c4f-9237-3743934715e8" providerId="ADAL" clId="{9B1EF873-2902-46D0-9BC9-FAD3E957ECD0}" dt="2025-03-19T14:43:00.802" v="1168" actId="1035"/>
          <ac:cxnSpMkLst>
            <pc:docMk/>
            <pc:sldMk cId="3007879694" sldId="256"/>
            <ac:cxnSpMk id="61" creationId="{16399156-112F-1865-EB56-3FD13E875AAB}"/>
          </ac:cxnSpMkLst>
        </pc:cxnChg>
        <pc:cxnChg chg="add mod">
          <ac:chgData name="Fox, Elizabeth" userId="c7619ef2-11a7-4c4f-9237-3743934715e8" providerId="ADAL" clId="{9B1EF873-2902-46D0-9BC9-FAD3E957ECD0}" dt="2025-03-19T14:43:00.802" v="1168" actId="1035"/>
          <ac:cxnSpMkLst>
            <pc:docMk/>
            <pc:sldMk cId="3007879694" sldId="256"/>
            <ac:cxnSpMk id="63" creationId="{77DDEECA-3645-4345-5DA2-8D346922927D}"/>
          </ac:cxnSpMkLst>
        </pc:cxnChg>
        <pc:cxnChg chg="mod">
          <ac:chgData name="Fox, Elizabeth" userId="c7619ef2-11a7-4c4f-9237-3743934715e8" providerId="ADAL" clId="{9B1EF873-2902-46D0-9BC9-FAD3E957ECD0}" dt="2025-03-19T14:08:51.436" v="784" actId="1076"/>
          <ac:cxnSpMkLst>
            <pc:docMk/>
            <pc:sldMk cId="3007879694" sldId="256"/>
            <ac:cxnSpMk id="65" creationId="{BCEB3DDB-B8AA-4C3A-BBD7-E93392E29C99}"/>
          </ac:cxnSpMkLst>
        </pc:cxnChg>
        <pc:cxnChg chg="add mod">
          <ac:chgData name="Fox, Elizabeth" userId="c7619ef2-11a7-4c4f-9237-3743934715e8" providerId="ADAL" clId="{9B1EF873-2902-46D0-9BC9-FAD3E957ECD0}" dt="2025-03-19T14:47:15.709" v="1212" actId="14100"/>
          <ac:cxnSpMkLst>
            <pc:docMk/>
            <pc:sldMk cId="3007879694" sldId="256"/>
            <ac:cxnSpMk id="67" creationId="{3863DE0A-141D-E8B6-2265-61090D67F436}"/>
          </ac:cxnSpMkLst>
        </pc:cxnChg>
        <pc:cxnChg chg="add mod">
          <ac:chgData name="Fox, Elizabeth" userId="c7619ef2-11a7-4c4f-9237-3743934715e8" providerId="ADAL" clId="{9B1EF873-2902-46D0-9BC9-FAD3E957ECD0}" dt="2025-03-19T14:26:08.954" v="1066" actId="1076"/>
          <ac:cxnSpMkLst>
            <pc:docMk/>
            <pc:sldMk cId="3007879694" sldId="256"/>
            <ac:cxnSpMk id="79" creationId="{B470D193-F31C-89B1-27D7-9F5893D090BD}"/>
          </ac:cxnSpMkLst>
        </pc:cxnChg>
        <pc:cxnChg chg="add del mod">
          <ac:chgData name="Fox, Elizabeth" userId="c7619ef2-11a7-4c4f-9237-3743934715e8" providerId="ADAL" clId="{9B1EF873-2902-46D0-9BC9-FAD3E957ECD0}" dt="2025-03-19T14:25:11.253" v="1060" actId="478"/>
          <ac:cxnSpMkLst>
            <pc:docMk/>
            <pc:sldMk cId="3007879694" sldId="256"/>
            <ac:cxnSpMk id="81" creationId="{22A04716-28B1-E900-1BA7-BFD698832788}"/>
          </ac:cxnSpMkLst>
        </pc:cxnChg>
        <pc:cxnChg chg="add mod">
          <ac:chgData name="Fox, Elizabeth" userId="c7619ef2-11a7-4c4f-9237-3743934715e8" providerId="ADAL" clId="{9B1EF873-2902-46D0-9BC9-FAD3E957ECD0}" dt="2025-03-19T14:26:17.518" v="1068" actId="14100"/>
          <ac:cxnSpMkLst>
            <pc:docMk/>
            <pc:sldMk cId="3007879694" sldId="256"/>
            <ac:cxnSpMk id="82" creationId="{3DDD1F91-9272-A3B5-AE2E-E06C9DB32CF0}"/>
          </ac:cxnSpMkLst>
        </pc:cxnChg>
        <pc:cxnChg chg="mod">
          <ac:chgData name="Fox, Elizabeth" userId="c7619ef2-11a7-4c4f-9237-3743934715e8" providerId="ADAL" clId="{9B1EF873-2902-46D0-9BC9-FAD3E957ECD0}" dt="2025-03-19T15:13:30.936" v="1247" actId="1076"/>
          <ac:cxnSpMkLst>
            <pc:docMk/>
            <pc:sldMk cId="3007879694" sldId="256"/>
            <ac:cxnSpMk id="85" creationId="{21C15718-3CBE-47D6-C501-184593EFC664}"/>
          </ac:cxnSpMkLst>
        </pc:cxnChg>
        <pc:cxnChg chg="del mod">
          <ac:chgData name="Fox, Elizabeth" userId="c7619ef2-11a7-4c4f-9237-3743934715e8" providerId="ADAL" clId="{9B1EF873-2902-46D0-9BC9-FAD3E957ECD0}" dt="2025-03-19T11:57:58.216" v="476" actId="478"/>
          <ac:cxnSpMkLst>
            <pc:docMk/>
            <pc:sldMk cId="3007879694" sldId="256"/>
            <ac:cxnSpMk id="86" creationId="{9255C2D1-7042-4C00-AE8A-0319075AFDF3}"/>
          </ac:cxnSpMkLst>
        </pc:cxnChg>
        <pc:cxnChg chg="mod">
          <ac:chgData name="Fox, Elizabeth" userId="c7619ef2-11a7-4c4f-9237-3743934715e8" providerId="ADAL" clId="{9B1EF873-2902-46D0-9BC9-FAD3E957ECD0}" dt="2025-03-19T14:01:17.484" v="720" actId="1035"/>
          <ac:cxnSpMkLst>
            <pc:docMk/>
            <pc:sldMk cId="3007879694" sldId="256"/>
            <ac:cxnSpMk id="126" creationId="{BE48E71D-82C3-4D19-AB5C-9506F6B0070C}"/>
          </ac:cxnSpMkLst>
        </pc:cxnChg>
        <pc:cxnChg chg="del mod">
          <ac:chgData name="Fox, Elizabeth" userId="c7619ef2-11a7-4c4f-9237-3743934715e8" providerId="ADAL" clId="{9B1EF873-2902-46D0-9BC9-FAD3E957ECD0}" dt="2025-03-19T14:07:46.286" v="769" actId="478"/>
          <ac:cxnSpMkLst>
            <pc:docMk/>
            <pc:sldMk cId="3007879694" sldId="256"/>
            <ac:cxnSpMk id="170" creationId="{95561660-A653-9D89-93EB-13EEE4E57CAD}"/>
          </ac:cxnSpMkLst>
        </pc:cxnChg>
        <pc:cxnChg chg="del mod">
          <ac:chgData name="Fox, Elizabeth" userId="c7619ef2-11a7-4c4f-9237-3743934715e8" providerId="ADAL" clId="{9B1EF873-2902-46D0-9BC9-FAD3E957ECD0}" dt="2025-03-19T14:07:45.036" v="768" actId="478"/>
          <ac:cxnSpMkLst>
            <pc:docMk/>
            <pc:sldMk cId="3007879694" sldId="256"/>
            <ac:cxnSpMk id="189" creationId="{A63882B4-E4DC-77BC-07CD-FAFB45D971CA}"/>
          </ac:cxnSpMkLst>
        </pc:cxnChg>
        <pc:cxnChg chg="mod">
          <ac:chgData name="Fox, Elizabeth" userId="c7619ef2-11a7-4c4f-9237-3743934715e8" providerId="ADAL" clId="{9B1EF873-2902-46D0-9BC9-FAD3E957ECD0}" dt="2025-03-19T14:43:00.802" v="1168" actId="1035"/>
          <ac:cxnSpMkLst>
            <pc:docMk/>
            <pc:sldMk cId="3007879694" sldId="256"/>
            <ac:cxnSpMk id="191" creationId="{BCECF2AA-07A7-645E-8E66-21E83619D04B}"/>
          </ac:cxnSpMkLst>
        </pc:cxnChg>
        <pc:cxnChg chg="del mod">
          <ac:chgData name="Fox, Elizabeth" userId="c7619ef2-11a7-4c4f-9237-3743934715e8" providerId="ADAL" clId="{9B1EF873-2902-46D0-9BC9-FAD3E957ECD0}" dt="2025-03-19T13:57:50.225" v="662" actId="478"/>
          <ac:cxnSpMkLst>
            <pc:docMk/>
            <pc:sldMk cId="3007879694" sldId="256"/>
            <ac:cxnSpMk id="195" creationId="{F2A447CF-FD87-ABCA-079A-9B73787BF8C1}"/>
          </ac:cxnSpMkLst>
        </pc:cxnChg>
      </pc:sldChg>
      <pc:sldChg chg="addSp delSp modSp add mod">
        <pc:chgData name="Fox, Elizabeth" userId="c7619ef2-11a7-4c4f-9237-3743934715e8" providerId="ADAL" clId="{9B1EF873-2902-46D0-9BC9-FAD3E957ECD0}" dt="2025-03-19T15:17:24.822" v="1271" actId="207"/>
        <pc:sldMkLst>
          <pc:docMk/>
          <pc:sldMk cId="1286145911" sldId="257"/>
        </pc:sldMkLst>
        <pc:spChg chg="add del mod">
          <ac:chgData name="Fox, Elizabeth" userId="c7619ef2-11a7-4c4f-9237-3743934715e8" providerId="ADAL" clId="{9B1EF873-2902-46D0-9BC9-FAD3E957ECD0}" dt="2025-03-19T14:50:12.387" v="1222" actId="478"/>
          <ac:spMkLst>
            <pc:docMk/>
            <pc:sldMk cId="1286145911" sldId="257"/>
            <ac:spMk id="3" creationId="{C4209994-4F89-8DED-61A3-FB1AD04BC066}"/>
          </ac:spMkLst>
        </pc:spChg>
        <pc:spChg chg="add del mod">
          <ac:chgData name="Fox, Elizabeth" userId="c7619ef2-11a7-4c4f-9237-3743934715e8" providerId="ADAL" clId="{9B1EF873-2902-46D0-9BC9-FAD3E957ECD0}" dt="2025-03-19T14:50:11.380" v="1221" actId="478"/>
          <ac:spMkLst>
            <pc:docMk/>
            <pc:sldMk cId="1286145911" sldId="257"/>
            <ac:spMk id="4" creationId="{C5372846-E255-C921-7E08-11635A891F1B}"/>
          </ac:spMkLst>
        </pc:spChg>
        <pc:spChg chg="add del mod">
          <ac:chgData name="Fox, Elizabeth" userId="c7619ef2-11a7-4c4f-9237-3743934715e8" providerId="ADAL" clId="{9B1EF873-2902-46D0-9BC9-FAD3E957ECD0}" dt="2025-03-19T14:59:31.662" v="1227" actId="478"/>
          <ac:spMkLst>
            <pc:docMk/>
            <pc:sldMk cId="1286145911" sldId="257"/>
            <ac:spMk id="5" creationId="{3867CA03-708C-706B-9E54-58CC4EC4427E}"/>
          </ac:spMkLst>
        </pc:spChg>
        <pc:spChg chg="mod">
          <ac:chgData name="Fox, Elizabeth" userId="c7619ef2-11a7-4c4f-9237-3743934715e8" providerId="ADAL" clId="{9B1EF873-2902-46D0-9BC9-FAD3E957ECD0}" dt="2025-03-19T15:17:18.043" v="1268" actId="207"/>
          <ac:spMkLst>
            <pc:docMk/>
            <pc:sldMk cId="1286145911" sldId="257"/>
            <ac:spMk id="51" creationId="{4D54160F-852C-6A4B-ED2B-C29AFF46AE97}"/>
          </ac:spMkLst>
        </pc:spChg>
        <pc:spChg chg="mod">
          <ac:chgData name="Fox, Elizabeth" userId="c7619ef2-11a7-4c4f-9237-3743934715e8" providerId="ADAL" clId="{9B1EF873-2902-46D0-9BC9-FAD3E957ECD0}" dt="2025-03-19T15:17:20.729" v="1269" actId="207"/>
          <ac:spMkLst>
            <pc:docMk/>
            <pc:sldMk cId="1286145911" sldId="257"/>
            <ac:spMk id="55" creationId="{C4D6F9AD-6574-2B40-76CB-7E7BEB1AC837}"/>
          </ac:spMkLst>
        </pc:spChg>
        <pc:spChg chg="mod">
          <ac:chgData name="Fox, Elizabeth" userId="c7619ef2-11a7-4c4f-9237-3743934715e8" providerId="ADAL" clId="{9B1EF873-2902-46D0-9BC9-FAD3E957ECD0}" dt="2025-03-19T15:17:22.776" v="1270" actId="207"/>
          <ac:spMkLst>
            <pc:docMk/>
            <pc:sldMk cId="1286145911" sldId="257"/>
            <ac:spMk id="56" creationId="{0292F8EC-02F0-61A2-2C5C-13DDF1F867AC}"/>
          </ac:spMkLst>
        </pc:spChg>
        <pc:spChg chg="mod">
          <ac:chgData name="Fox, Elizabeth" userId="c7619ef2-11a7-4c4f-9237-3743934715e8" providerId="ADAL" clId="{9B1EF873-2902-46D0-9BC9-FAD3E957ECD0}" dt="2025-03-19T15:17:24.822" v="1271" actId="207"/>
          <ac:spMkLst>
            <pc:docMk/>
            <pc:sldMk cId="1286145911" sldId="257"/>
            <ac:spMk id="58" creationId="{C41B943D-216D-57B3-46ED-519B4AA03D0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53717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495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83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237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053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3310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102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644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55979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361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249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D1C00-75C3-4282-82CD-5B001D12A04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2BA532-DD78-4264-8313-9590B8EE6E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262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26" name="Straight Arrow Connector 125">
            <a:extLst>
              <a:ext uri="{FF2B5EF4-FFF2-40B4-BE49-F238E27FC236}">
                <a16:creationId xmlns:a16="http://schemas.microsoft.com/office/drawing/2014/main" id="{BE48E71D-82C3-4D19-AB5C-9506F6B0070C}"/>
              </a:ext>
            </a:extLst>
          </p:cNvPr>
          <p:cNvCxnSpPr>
            <a:cxnSpLocks/>
          </p:cNvCxnSpPr>
          <p:nvPr/>
        </p:nvCxnSpPr>
        <p:spPr>
          <a:xfrm>
            <a:off x="1345382" y="5679860"/>
            <a:ext cx="0" cy="69679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Parallelogram 9">
            <a:extLst>
              <a:ext uri="{FF2B5EF4-FFF2-40B4-BE49-F238E27FC236}">
                <a16:creationId xmlns:a16="http://schemas.microsoft.com/office/drawing/2014/main" id="{F0DAAD06-8276-40F6-A26E-DCD751AF63D7}"/>
              </a:ext>
            </a:extLst>
          </p:cNvPr>
          <p:cNvSpPr/>
          <p:nvPr/>
        </p:nvSpPr>
        <p:spPr>
          <a:xfrm>
            <a:off x="764168" y="1458876"/>
            <a:ext cx="1380692" cy="1073214"/>
          </a:xfrm>
          <a:prstGeom prst="parallelogram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5720" rIns="45720"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1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Develop Process for Collecting &amp; Prioritizing  Feedback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D77E9862-BD50-433F-BC70-5A1A27A21E01}"/>
              </a:ext>
            </a:extLst>
          </p:cNvPr>
          <p:cNvSpPr/>
          <p:nvPr/>
        </p:nvSpPr>
        <p:spPr>
          <a:xfrm>
            <a:off x="2493070" y="1630788"/>
            <a:ext cx="1227909" cy="850789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2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Establish Customer Feedback Mechanism(s)</a:t>
            </a:r>
            <a:r>
              <a:rPr lang="en-US" sz="1100" baseline="30000" dirty="0">
                <a:solidFill>
                  <a:sysClr val="windowText" lastClr="000000"/>
                </a:solidFill>
              </a:rPr>
              <a:t>1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7CD389C0-F022-4EB4-A21D-D21FD76EEC25}"/>
              </a:ext>
            </a:extLst>
          </p:cNvPr>
          <p:cNvSpPr/>
          <p:nvPr/>
        </p:nvSpPr>
        <p:spPr>
          <a:xfrm>
            <a:off x="2480182" y="3152042"/>
            <a:ext cx="1227909" cy="850789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6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Triage Complaints &amp; Assign Ownership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05FF95FA-99E2-4686-BED5-3ED60C0A5193}"/>
              </a:ext>
            </a:extLst>
          </p:cNvPr>
          <p:cNvSpPr/>
          <p:nvPr/>
        </p:nvSpPr>
        <p:spPr>
          <a:xfrm>
            <a:off x="5899600" y="3147984"/>
            <a:ext cx="1227909" cy="847663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5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Analyze Customer Feedback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77CFF669-0751-45C8-9079-C0DA62F0D433}"/>
              </a:ext>
            </a:extLst>
          </p:cNvPr>
          <p:cNvSpPr/>
          <p:nvPr/>
        </p:nvSpPr>
        <p:spPr>
          <a:xfrm>
            <a:off x="2515074" y="4968426"/>
            <a:ext cx="1227909" cy="850788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8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Conduct Complaint Investigation</a:t>
            </a:r>
            <a:r>
              <a:rPr lang="en-US" sz="1100" baseline="30000" dirty="0">
                <a:solidFill>
                  <a:sysClr val="windowText" lastClr="000000"/>
                </a:solidFill>
              </a:rPr>
              <a:t>2</a:t>
            </a:r>
          </a:p>
        </p:txBody>
      </p:sp>
      <p:sp>
        <p:nvSpPr>
          <p:cNvPr id="29" name="Flowchart: Decision 28">
            <a:extLst>
              <a:ext uri="{FF2B5EF4-FFF2-40B4-BE49-F238E27FC236}">
                <a16:creationId xmlns:a16="http://schemas.microsoft.com/office/drawing/2014/main" id="{F73C9F69-2379-492B-9C79-1ACA3D7A8465}"/>
              </a:ext>
            </a:extLst>
          </p:cNvPr>
          <p:cNvSpPr/>
          <p:nvPr/>
        </p:nvSpPr>
        <p:spPr>
          <a:xfrm>
            <a:off x="1084291" y="5131220"/>
            <a:ext cx="548640" cy="548640"/>
          </a:xfrm>
          <a:prstGeom prst="flowChartDecision">
            <a:avLst/>
          </a:prstGeom>
          <a:solidFill>
            <a:srgbClr val="A6F0F8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Flowchart: Document 32">
            <a:extLst>
              <a:ext uri="{FF2B5EF4-FFF2-40B4-BE49-F238E27FC236}">
                <a16:creationId xmlns:a16="http://schemas.microsoft.com/office/drawing/2014/main" id="{9BF96916-7180-4FC6-9122-60E62D54B8AF}"/>
              </a:ext>
            </a:extLst>
          </p:cNvPr>
          <p:cNvSpPr/>
          <p:nvPr/>
        </p:nvSpPr>
        <p:spPr>
          <a:xfrm>
            <a:off x="5932905" y="7316694"/>
            <a:ext cx="1193073" cy="847662"/>
          </a:xfrm>
          <a:prstGeom prst="flowChartDocumen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91440" rtlCol="0" anchor="t" anchorCtr="0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10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Develop Close-Out Report</a:t>
            </a:r>
          </a:p>
        </p:txBody>
      </p:sp>
      <p:sp>
        <p:nvSpPr>
          <p:cNvPr id="38" name="Flowchart: Terminator 37">
            <a:extLst>
              <a:ext uri="{FF2B5EF4-FFF2-40B4-BE49-F238E27FC236}">
                <a16:creationId xmlns:a16="http://schemas.microsoft.com/office/drawing/2014/main" id="{1545E607-9759-4D15-BD41-F54C6F126183}"/>
              </a:ext>
            </a:extLst>
          </p:cNvPr>
          <p:cNvSpPr/>
          <p:nvPr/>
        </p:nvSpPr>
        <p:spPr>
          <a:xfrm>
            <a:off x="1190071" y="558836"/>
            <a:ext cx="528883" cy="180934"/>
          </a:xfrm>
          <a:prstGeom prst="flowChartTerminator">
            <a:avLst/>
          </a:prstGeom>
          <a:solidFill>
            <a:schemeClr val="accent6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CF0D5C5C-57E4-4352-9D4D-087BCAE623FD}"/>
              </a:ext>
            </a:extLst>
          </p:cNvPr>
          <p:cNvCxnSpPr>
            <a:cxnSpLocks/>
            <a:stCxn id="133" idx="2"/>
            <a:endCxn id="10" idx="0"/>
          </p:cNvCxnSpPr>
          <p:nvPr/>
        </p:nvCxnSpPr>
        <p:spPr>
          <a:xfrm>
            <a:off x="1454514" y="1043729"/>
            <a:ext cx="0" cy="41514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EE0D6D5-77B7-4AE6-AAE7-E9B70B383443}"/>
              </a:ext>
            </a:extLst>
          </p:cNvPr>
          <p:cNvCxnSpPr>
            <a:cxnSpLocks/>
          </p:cNvCxnSpPr>
          <p:nvPr/>
        </p:nvCxnSpPr>
        <p:spPr>
          <a:xfrm>
            <a:off x="2001574" y="2054358"/>
            <a:ext cx="44235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E18B6460-DB1A-414A-A484-632141826535}"/>
              </a:ext>
            </a:extLst>
          </p:cNvPr>
          <p:cNvCxnSpPr>
            <a:cxnSpLocks/>
          </p:cNvCxnSpPr>
          <p:nvPr/>
        </p:nvCxnSpPr>
        <p:spPr>
          <a:xfrm>
            <a:off x="6513553" y="2481577"/>
            <a:ext cx="0" cy="66310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0CB0B4DD-8EB5-4009-9B9E-22343EC5C0C3}"/>
              </a:ext>
            </a:extLst>
          </p:cNvPr>
          <p:cNvCxnSpPr>
            <a:cxnSpLocks/>
            <a:endCxn id="29" idx="0"/>
          </p:cNvCxnSpPr>
          <p:nvPr/>
        </p:nvCxnSpPr>
        <p:spPr>
          <a:xfrm>
            <a:off x="1358611" y="3825658"/>
            <a:ext cx="0" cy="130556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BCEB3DDB-B8AA-4C3A-BBD7-E93392E29C99}"/>
              </a:ext>
            </a:extLst>
          </p:cNvPr>
          <p:cNvCxnSpPr>
            <a:cxnSpLocks/>
            <a:stCxn id="29" idx="3"/>
            <a:endCxn id="28" idx="1"/>
          </p:cNvCxnSpPr>
          <p:nvPr/>
        </p:nvCxnSpPr>
        <p:spPr>
          <a:xfrm flipV="1">
            <a:off x="1632931" y="5393820"/>
            <a:ext cx="882143" cy="1172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4" name="TextBox 123">
            <a:extLst>
              <a:ext uri="{FF2B5EF4-FFF2-40B4-BE49-F238E27FC236}">
                <a16:creationId xmlns:a16="http://schemas.microsoft.com/office/drawing/2014/main" id="{674448F4-E74C-4EC3-9527-12197CF0E881}"/>
              </a:ext>
            </a:extLst>
          </p:cNvPr>
          <p:cNvSpPr txBox="1"/>
          <p:nvPr/>
        </p:nvSpPr>
        <p:spPr>
          <a:xfrm>
            <a:off x="1094084" y="5867757"/>
            <a:ext cx="529054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No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D30DFE23-69C3-47EE-AF80-7E5A8DC45E20}"/>
              </a:ext>
            </a:extLst>
          </p:cNvPr>
          <p:cNvSpPr txBox="1"/>
          <p:nvPr/>
        </p:nvSpPr>
        <p:spPr>
          <a:xfrm>
            <a:off x="1954445" y="5265250"/>
            <a:ext cx="259786" cy="261610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ctr"/>
            <a:r>
              <a:rPr lang="en-US" sz="1100" dirty="0"/>
              <a:t>Yes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F1C6DF61-B485-4BD3-9F7A-2A75BA971966}"/>
              </a:ext>
            </a:extLst>
          </p:cNvPr>
          <p:cNvSpPr txBox="1"/>
          <p:nvPr/>
        </p:nvSpPr>
        <p:spPr>
          <a:xfrm>
            <a:off x="1152669" y="8913885"/>
            <a:ext cx="5288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End</a:t>
            </a:r>
          </a:p>
        </p:txBody>
      </p:sp>
      <p:sp>
        <p:nvSpPr>
          <p:cNvPr id="4" name="Flowchart: Decision 3">
            <a:extLst>
              <a:ext uri="{FF2B5EF4-FFF2-40B4-BE49-F238E27FC236}">
                <a16:creationId xmlns:a16="http://schemas.microsoft.com/office/drawing/2014/main" id="{533AB7EE-28B5-6049-A803-3DEAC0E3BE85}"/>
              </a:ext>
            </a:extLst>
          </p:cNvPr>
          <p:cNvSpPr/>
          <p:nvPr/>
        </p:nvSpPr>
        <p:spPr>
          <a:xfrm>
            <a:off x="4332413" y="3293513"/>
            <a:ext cx="548640" cy="548640"/>
          </a:xfrm>
          <a:prstGeom prst="flowChartDecision">
            <a:avLst/>
          </a:prstGeom>
          <a:solidFill>
            <a:srgbClr val="A6F0F8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1699A68-24B1-5651-BAED-894E09C86007}"/>
              </a:ext>
            </a:extLst>
          </p:cNvPr>
          <p:cNvSpPr/>
          <p:nvPr/>
        </p:nvSpPr>
        <p:spPr>
          <a:xfrm>
            <a:off x="4101811" y="4319564"/>
            <a:ext cx="1009844" cy="317726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Go to Step 12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6917EB4A-BB93-A338-8DC1-B2A54D33D073}"/>
              </a:ext>
            </a:extLst>
          </p:cNvPr>
          <p:cNvCxnSpPr>
            <a:cxnSpLocks/>
            <a:stCxn id="27" idx="1"/>
          </p:cNvCxnSpPr>
          <p:nvPr/>
        </p:nvCxnSpPr>
        <p:spPr>
          <a:xfrm flipH="1">
            <a:off x="4889757" y="3571816"/>
            <a:ext cx="100984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21C15718-3CBE-47D6-C501-184593EFC664}"/>
              </a:ext>
            </a:extLst>
          </p:cNvPr>
          <p:cNvCxnSpPr>
            <a:cxnSpLocks/>
            <a:stCxn id="4" idx="2"/>
            <a:endCxn id="5" idx="0"/>
          </p:cNvCxnSpPr>
          <p:nvPr/>
        </p:nvCxnSpPr>
        <p:spPr>
          <a:xfrm>
            <a:off x="4606733" y="3842153"/>
            <a:ext cx="0" cy="47741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7" name="Flowchart: Terminator 136">
            <a:extLst>
              <a:ext uri="{FF2B5EF4-FFF2-40B4-BE49-F238E27FC236}">
                <a16:creationId xmlns:a16="http://schemas.microsoft.com/office/drawing/2014/main" id="{1E10791E-0645-7A8D-3CD0-A66775CB4CDE}"/>
              </a:ext>
            </a:extLst>
          </p:cNvPr>
          <p:cNvSpPr/>
          <p:nvPr/>
        </p:nvSpPr>
        <p:spPr>
          <a:xfrm>
            <a:off x="1152669" y="8712777"/>
            <a:ext cx="528883" cy="201108"/>
          </a:xfrm>
          <a:prstGeom prst="flowChartTerminator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4D00D8A1-3B0C-41F3-A00D-E6227C0EEFD6}"/>
              </a:ext>
            </a:extLst>
          </p:cNvPr>
          <p:cNvSpPr txBox="1"/>
          <p:nvPr/>
        </p:nvSpPr>
        <p:spPr>
          <a:xfrm>
            <a:off x="1190072" y="782119"/>
            <a:ext cx="528883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Start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F519353C-ACB2-009D-71DD-DA957017DA1D}"/>
              </a:ext>
            </a:extLst>
          </p:cNvPr>
          <p:cNvSpPr txBox="1"/>
          <p:nvPr/>
        </p:nvSpPr>
        <p:spPr>
          <a:xfrm>
            <a:off x="192040" y="9260010"/>
            <a:ext cx="7388317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28600" indent="-228600">
              <a:buAutoNum type="arabicPeriod"/>
            </a:pPr>
            <a:r>
              <a:rPr lang="en-US" sz="1100" dirty="0">
                <a:solidFill>
                  <a:sysClr val="windowText" lastClr="000000"/>
                </a:solidFill>
              </a:rPr>
              <a:t>e.g., customer satisfaction surveys, portal, focus groups</a:t>
            </a:r>
          </a:p>
          <a:p>
            <a:pPr marL="228600" indent="-228600">
              <a:buAutoNum type="arabicPeriod"/>
            </a:pPr>
            <a:r>
              <a:rPr lang="en-US" sz="1100" dirty="0">
                <a:solidFill>
                  <a:sysClr val="windowText" lastClr="000000"/>
                </a:solidFill>
              </a:rPr>
              <a:t>Lab investigation can include re-tests using additional samples or customer-returned samples, comparative analysis, coordination of third-party testing, etc.</a:t>
            </a:r>
          </a:p>
          <a:p>
            <a:pPr marL="228600" indent="-228600">
              <a:buAutoNum type="arabicPeriod"/>
            </a:pPr>
            <a:r>
              <a:rPr lang="en-US" sz="1100" dirty="0">
                <a:solidFill>
                  <a:sysClr val="windowText" lastClr="000000"/>
                </a:solidFill>
              </a:rPr>
              <a:t>CAPA = Corrective and Preventive Action</a:t>
            </a:r>
          </a:p>
        </p:txBody>
      </p:sp>
      <p:sp>
        <p:nvSpPr>
          <p:cNvPr id="164" name="Parallelogram 163">
            <a:extLst>
              <a:ext uri="{FF2B5EF4-FFF2-40B4-BE49-F238E27FC236}">
                <a16:creationId xmlns:a16="http://schemas.microsoft.com/office/drawing/2014/main" id="{5CC554D3-F1A4-B9F5-270F-5E1BFC66F060}"/>
              </a:ext>
            </a:extLst>
          </p:cNvPr>
          <p:cNvSpPr/>
          <p:nvPr/>
        </p:nvSpPr>
        <p:spPr>
          <a:xfrm>
            <a:off x="4087604" y="7316694"/>
            <a:ext cx="1441087" cy="847662"/>
          </a:xfrm>
          <a:prstGeom prst="parallelogram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11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Communicate Findings</a:t>
            </a:r>
          </a:p>
        </p:txBody>
      </p:sp>
      <p:sp>
        <p:nvSpPr>
          <p:cNvPr id="167" name="Rectangle 166">
            <a:extLst>
              <a:ext uri="{FF2B5EF4-FFF2-40B4-BE49-F238E27FC236}">
                <a16:creationId xmlns:a16="http://schemas.microsoft.com/office/drawing/2014/main" id="{877705AE-1A4C-4EC4-EC05-BB62135314F2}"/>
              </a:ext>
            </a:extLst>
          </p:cNvPr>
          <p:cNvSpPr/>
          <p:nvPr/>
        </p:nvSpPr>
        <p:spPr>
          <a:xfrm>
            <a:off x="5932905" y="4968426"/>
            <a:ext cx="1194604" cy="850788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9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Implement Action Items</a:t>
            </a:r>
          </a:p>
        </p:txBody>
      </p:sp>
      <p:sp>
        <p:nvSpPr>
          <p:cNvPr id="169" name="Rectangle 168">
            <a:extLst>
              <a:ext uri="{FF2B5EF4-FFF2-40B4-BE49-F238E27FC236}">
                <a16:creationId xmlns:a16="http://schemas.microsoft.com/office/drawing/2014/main" id="{A89AB435-1ECE-C589-CE4B-8C89BDDC4852}"/>
              </a:ext>
            </a:extLst>
          </p:cNvPr>
          <p:cNvSpPr/>
          <p:nvPr/>
        </p:nvSpPr>
        <p:spPr>
          <a:xfrm>
            <a:off x="916954" y="6396781"/>
            <a:ext cx="904163" cy="345329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Go to Step 9</a:t>
            </a:r>
          </a:p>
        </p:txBody>
      </p:sp>
      <p:cxnSp>
        <p:nvCxnSpPr>
          <p:cNvPr id="191" name="Straight Arrow Connector 190">
            <a:extLst>
              <a:ext uri="{FF2B5EF4-FFF2-40B4-BE49-F238E27FC236}">
                <a16:creationId xmlns:a16="http://schemas.microsoft.com/office/drawing/2014/main" id="{BCECF2AA-07A7-645E-8E66-21E83619D04B}"/>
              </a:ext>
            </a:extLst>
          </p:cNvPr>
          <p:cNvCxnSpPr>
            <a:cxnSpLocks/>
            <a:endCxn id="137" idx="0"/>
          </p:cNvCxnSpPr>
          <p:nvPr/>
        </p:nvCxnSpPr>
        <p:spPr>
          <a:xfrm>
            <a:off x="1417111" y="8164356"/>
            <a:ext cx="0" cy="54842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Parallelogram 22">
            <a:extLst>
              <a:ext uri="{FF2B5EF4-FFF2-40B4-BE49-F238E27FC236}">
                <a16:creationId xmlns:a16="http://schemas.microsoft.com/office/drawing/2014/main" id="{F00342B0-F987-FC6A-29DE-6F881E6B1623}"/>
              </a:ext>
            </a:extLst>
          </p:cNvPr>
          <p:cNvSpPr/>
          <p:nvPr/>
        </p:nvSpPr>
        <p:spPr>
          <a:xfrm>
            <a:off x="5899600" y="1457603"/>
            <a:ext cx="1491795" cy="1016005"/>
          </a:xfrm>
          <a:prstGeom prst="parallelogram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4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Collect Customer Feedback at Established Interval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A5361CD-9341-0C29-4CAA-B89362DDF75A}"/>
              </a:ext>
            </a:extLst>
          </p:cNvPr>
          <p:cNvSpPr txBox="1"/>
          <p:nvPr/>
        </p:nvSpPr>
        <p:spPr>
          <a:xfrm>
            <a:off x="5083200" y="3402346"/>
            <a:ext cx="695576" cy="33855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b="1" i="1" dirty="0"/>
              <a:t>Complaint Received?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072B163-C343-F479-11B3-20D7A967B200}"/>
              </a:ext>
            </a:extLst>
          </p:cNvPr>
          <p:cNvSpPr txBox="1"/>
          <p:nvPr/>
        </p:nvSpPr>
        <p:spPr>
          <a:xfrm>
            <a:off x="4505904" y="3916811"/>
            <a:ext cx="238431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dirty="0"/>
              <a:t>No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F2A4347-05ED-4596-AB59-FDA7AE84A45E}"/>
              </a:ext>
            </a:extLst>
          </p:cNvPr>
          <p:cNvSpPr txBox="1"/>
          <p:nvPr/>
        </p:nvSpPr>
        <p:spPr>
          <a:xfrm>
            <a:off x="872651" y="4296886"/>
            <a:ext cx="992767" cy="50783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b="1" i="1" dirty="0"/>
              <a:t>Lab Investigation Required?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8BB99208-8573-A7BA-A354-9E8CC7E6766F}"/>
              </a:ext>
            </a:extLst>
          </p:cNvPr>
          <p:cNvCxnSpPr>
            <a:cxnSpLocks/>
            <a:stCxn id="4" idx="1"/>
          </p:cNvCxnSpPr>
          <p:nvPr/>
        </p:nvCxnSpPr>
        <p:spPr>
          <a:xfrm flipH="1">
            <a:off x="3720979" y="3567833"/>
            <a:ext cx="61143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9AC57011-5297-B432-85C9-3C50B8623F80}"/>
              </a:ext>
            </a:extLst>
          </p:cNvPr>
          <p:cNvSpPr txBox="1"/>
          <p:nvPr/>
        </p:nvSpPr>
        <p:spPr>
          <a:xfrm>
            <a:off x="3890435" y="3437028"/>
            <a:ext cx="286892" cy="261610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ctr"/>
            <a:r>
              <a:rPr lang="en-US" sz="1100" dirty="0"/>
              <a:t>Yes</a:t>
            </a: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644148E5-C0E5-AACF-D0B8-9417FE1912D8}"/>
              </a:ext>
            </a:extLst>
          </p:cNvPr>
          <p:cNvCxnSpPr>
            <a:cxnSpLocks/>
            <a:stCxn id="28" idx="3"/>
          </p:cNvCxnSpPr>
          <p:nvPr/>
        </p:nvCxnSpPr>
        <p:spPr>
          <a:xfrm>
            <a:off x="3742983" y="5393820"/>
            <a:ext cx="113807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566BF526-5270-7E17-394E-FCB6E15FA30A}"/>
              </a:ext>
            </a:extLst>
          </p:cNvPr>
          <p:cNvSpPr/>
          <p:nvPr/>
        </p:nvSpPr>
        <p:spPr>
          <a:xfrm flipH="1">
            <a:off x="-1" y="595"/>
            <a:ext cx="7772400" cy="271961"/>
          </a:xfrm>
          <a:prstGeom prst="rect">
            <a:avLst/>
          </a:prstGeom>
          <a:gradFill flip="none" rotWithShape="1">
            <a:gsLst>
              <a:gs pos="2000">
                <a:srgbClr val="027CBA"/>
              </a:gs>
              <a:gs pos="94000">
                <a:schemeClr val="accent1">
                  <a:lumMod val="5000"/>
                  <a:lumOff val="95000"/>
                </a:schemeClr>
              </a:gs>
            </a:gsLst>
            <a:lin ang="10800000" scaled="0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/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b="1" kern="120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emplate Example</a:t>
            </a:r>
            <a:endParaRPr lang="en-US" sz="10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033A3F5-E1D2-65D6-24A0-1C6363F02510}"/>
              </a:ext>
            </a:extLst>
          </p:cNvPr>
          <p:cNvSpPr/>
          <p:nvPr/>
        </p:nvSpPr>
        <p:spPr>
          <a:xfrm>
            <a:off x="4204900" y="1610116"/>
            <a:ext cx="1227909" cy="867051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3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Distribute/Launch Customer Feedback Mechanism(s)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66C2FD67-C55C-C5F0-694A-73F3AFCAF003}"/>
              </a:ext>
            </a:extLst>
          </p:cNvPr>
          <p:cNvCxnSpPr>
            <a:cxnSpLocks/>
          </p:cNvCxnSpPr>
          <p:nvPr/>
        </p:nvCxnSpPr>
        <p:spPr>
          <a:xfrm>
            <a:off x="3725502" y="2055537"/>
            <a:ext cx="45989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9D454FDF-E4F8-1535-A147-C779E493F2B5}"/>
              </a:ext>
            </a:extLst>
          </p:cNvPr>
          <p:cNvCxnSpPr>
            <a:cxnSpLocks/>
          </p:cNvCxnSpPr>
          <p:nvPr/>
        </p:nvCxnSpPr>
        <p:spPr>
          <a:xfrm>
            <a:off x="5429946" y="2050961"/>
            <a:ext cx="57153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Rectangle 15">
            <a:extLst>
              <a:ext uri="{FF2B5EF4-FFF2-40B4-BE49-F238E27FC236}">
                <a16:creationId xmlns:a16="http://schemas.microsoft.com/office/drawing/2014/main" id="{245643FF-E6B6-3D05-E15F-0CCF89E92FB5}"/>
              </a:ext>
            </a:extLst>
          </p:cNvPr>
          <p:cNvSpPr/>
          <p:nvPr/>
        </p:nvSpPr>
        <p:spPr>
          <a:xfrm>
            <a:off x="795437" y="3150020"/>
            <a:ext cx="1227909" cy="850788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7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Prioritize Complaints &amp; Identify Feasibility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52723BD1-CE4A-FC2B-CD74-1C46217E1DE6}"/>
              </a:ext>
            </a:extLst>
          </p:cNvPr>
          <p:cNvCxnSpPr>
            <a:cxnSpLocks/>
          </p:cNvCxnSpPr>
          <p:nvPr/>
        </p:nvCxnSpPr>
        <p:spPr>
          <a:xfrm flipH="1">
            <a:off x="2023583" y="3575414"/>
            <a:ext cx="45989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7F90B88D-754A-0BF3-3270-B93EA899110F}"/>
              </a:ext>
            </a:extLst>
          </p:cNvPr>
          <p:cNvCxnSpPr>
            <a:cxnSpLocks/>
            <a:stCxn id="33" idx="1"/>
          </p:cNvCxnSpPr>
          <p:nvPr/>
        </p:nvCxnSpPr>
        <p:spPr>
          <a:xfrm flipH="1" flipV="1">
            <a:off x="5420153" y="7733033"/>
            <a:ext cx="512752" cy="749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Rectangle 50">
            <a:extLst>
              <a:ext uri="{FF2B5EF4-FFF2-40B4-BE49-F238E27FC236}">
                <a16:creationId xmlns:a16="http://schemas.microsoft.com/office/drawing/2014/main" id="{097F897A-D76B-C43F-D304-7BC411850C6B}"/>
              </a:ext>
            </a:extLst>
          </p:cNvPr>
          <p:cNvSpPr/>
          <p:nvPr/>
        </p:nvSpPr>
        <p:spPr>
          <a:xfrm>
            <a:off x="2490194" y="7317882"/>
            <a:ext cx="1194604" cy="847662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12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Close Out Feedback Item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FE4FAB31-4744-C8C4-E6B2-5E60828C5FAE}"/>
              </a:ext>
            </a:extLst>
          </p:cNvPr>
          <p:cNvSpPr/>
          <p:nvPr/>
        </p:nvSpPr>
        <p:spPr>
          <a:xfrm>
            <a:off x="800867" y="7317882"/>
            <a:ext cx="1227909" cy="847662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13</a:t>
            </a:r>
          </a:p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Evaluate Effectiveness of Actions Taken</a:t>
            </a:r>
          </a:p>
        </p:txBody>
      </p: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16399156-112F-1865-EB56-3FD13E875AAB}"/>
              </a:ext>
            </a:extLst>
          </p:cNvPr>
          <p:cNvCxnSpPr>
            <a:cxnSpLocks/>
          </p:cNvCxnSpPr>
          <p:nvPr/>
        </p:nvCxnSpPr>
        <p:spPr>
          <a:xfrm flipH="1" flipV="1">
            <a:off x="3687744" y="7739321"/>
            <a:ext cx="497649" cy="12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77DDEECA-3645-4345-5DA2-8D346922927D}"/>
              </a:ext>
            </a:extLst>
          </p:cNvPr>
          <p:cNvCxnSpPr>
            <a:cxnSpLocks/>
          </p:cNvCxnSpPr>
          <p:nvPr/>
        </p:nvCxnSpPr>
        <p:spPr>
          <a:xfrm flipH="1" flipV="1">
            <a:off x="2028776" y="7737731"/>
            <a:ext cx="458472" cy="102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3863DE0A-141D-E8B6-2265-61090D67F436}"/>
              </a:ext>
            </a:extLst>
          </p:cNvPr>
          <p:cNvCxnSpPr>
            <a:cxnSpLocks/>
            <a:endCxn id="33" idx="0"/>
          </p:cNvCxnSpPr>
          <p:nvPr/>
        </p:nvCxnSpPr>
        <p:spPr>
          <a:xfrm>
            <a:off x="6528985" y="5819214"/>
            <a:ext cx="457" cy="149748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B470D193-F31C-89B1-27D7-9F5893D090BD}"/>
              </a:ext>
            </a:extLst>
          </p:cNvPr>
          <p:cNvCxnSpPr>
            <a:cxnSpLocks/>
          </p:cNvCxnSpPr>
          <p:nvPr/>
        </p:nvCxnSpPr>
        <p:spPr>
          <a:xfrm>
            <a:off x="5142397" y="5667323"/>
            <a:ext cx="0" cy="69679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Flowchart: Decision 79">
            <a:extLst>
              <a:ext uri="{FF2B5EF4-FFF2-40B4-BE49-F238E27FC236}">
                <a16:creationId xmlns:a16="http://schemas.microsoft.com/office/drawing/2014/main" id="{2ED590A2-8937-AC22-AC61-ECCBEDF4F2A6}"/>
              </a:ext>
            </a:extLst>
          </p:cNvPr>
          <p:cNvSpPr/>
          <p:nvPr/>
        </p:nvSpPr>
        <p:spPr>
          <a:xfrm>
            <a:off x="4881306" y="5118683"/>
            <a:ext cx="548640" cy="548640"/>
          </a:xfrm>
          <a:prstGeom prst="flowChartDecision">
            <a:avLst/>
          </a:prstGeom>
          <a:solidFill>
            <a:srgbClr val="A6F0F8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3DDD1F91-9272-A3B5-AE2E-E06C9DB32CF0}"/>
              </a:ext>
            </a:extLst>
          </p:cNvPr>
          <p:cNvCxnSpPr>
            <a:cxnSpLocks/>
            <a:stCxn id="80" idx="3"/>
            <a:endCxn id="167" idx="1"/>
          </p:cNvCxnSpPr>
          <p:nvPr/>
        </p:nvCxnSpPr>
        <p:spPr>
          <a:xfrm>
            <a:off x="5429946" y="5393003"/>
            <a:ext cx="502959" cy="81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B01FEE59-12A7-D12F-3CC0-CC00026C29E5}"/>
              </a:ext>
            </a:extLst>
          </p:cNvPr>
          <p:cNvSpPr txBox="1"/>
          <p:nvPr/>
        </p:nvSpPr>
        <p:spPr>
          <a:xfrm>
            <a:off x="4891099" y="5855220"/>
            <a:ext cx="529054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Yes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1AEDA3E7-A07C-F231-1CE2-411B82882A05}"/>
              </a:ext>
            </a:extLst>
          </p:cNvPr>
          <p:cNvSpPr txBox="1"/>
          <p:nvPr/>
        </p:nvSpPr>
        <p:spPr>
          <a:xfrm>
            <a:off x="5528692" y="5262198"/>
            <a:ext cx="259786" cy="261610"/>
          </a:xfrm>
          <a:prstGeom prst="rect">
            <a:avLst/>
          </a:prstGeom>
          <a:solidFill>
            <a:schemeClr val="bg1"/>
          </a:solidFill>
        </p:spPr>
        <p:txBody>
          <a:bodyPr wrap="square" lIns="0" rIns="0" rtlCol="0">
            <a:spAutoFit/>
          </a:bodyPr>
          <a:lstStyle/>
          <a:p>
            <a:pPr algn="ctr"/>
            <a:r>
              <a:rPr lang="en-US" sz="1100" dirty="0"/>
              <a:t>No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5171C296-F31E-1D94-3D0C-2D9AD60FCBDE}"/>
              </a:ext>
            </a:extLst>
          </p:cNvPr>
          <p:cNvSpPr txBox="1"/>
          <p:nvPr/>
        </p:nvSpPr>
        <p:spPr>
          <a:xfrm>
            <a:off x="3953674" y="5142259"/>
            <a:ext cx="618337" cy="50783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100" b="1" i="1" dirty="0"/>
              <a:t>Formal CAPA</a:t>
            </a:r>
            <a:r>
              <a:rPr lang="en-US" sz="1100" b="1" i="1" baseline="30000" dirty="0"/>
              <a:t>3</a:t>
            </a:r>
            <a:r>
              <a:rPr lang="en-US" sz="1100" b="1" i="1" dirty="0"/>
              <a:t> Required?</a:t>
            </a:r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CA4356AE-0F84-DBC3-1A89-90BF77E298FA}"/>
              </a:ext>
            </a:extLst>
          </p:cNvPr>
          <p:cNvSpPr/>
          <p:nvPr/>
        </p:nvSpPr>
        <p:spPr>
          <a:xfrm>
            <a:off x="4572011" y="6364119"/>
            <a:ext cx="1193073" cy="646111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ysClr val="windowText" lastClr="000000"/>
                </a:solidFill>
              </a:rPr>
              <a:t>Execute CAPA Process &amp; Reporting</a:t>
            </a:r>
          </a:p>
        </p:txBody>
      </p:sp>
    </p:spTree>
    <p:extLst>
      <p:ext uri="{BB962C8B-B14F-4D97-AF65-F5344CB8AC3E}">
        <p14:creationId xmlns:p14="http://schemas.microsoft.com/office/powerpoint/2010/main" val="30078796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TextBox 162">
            <a:extLst>
              <a:ext uri="{FF2B5EF4-FFF2-40B4-BE49-F238E27FC236}">
                <a16:creationId xmlns:a16="http://schemas.microsoft.com/office/drawing/2014/main" id="{F519353C-ACB2-009D-71DD-DA957017DA1D}"/>
              </a:ext>
            </a:extLst>
          </p:cNvPr>
          <p:cNvSpPr txBox="1"/>
          <p:nvPr/>
        </p:nvSpPr>
        <p:spPr>
          <a:xfrm>
            <a:off x="541338" y="974337"/>
            <a:ext cx="38862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ysClr val="windowText" lastClr="000000"/>
                </a:solidFill>
              </a:rPr>
              <a:t>Legend</a:t>
            </a:r>
            <a:endParaRPr lang="en-US" sz="1200" b="1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566BF526-5270-7E17-394E-FCB6E15FA30A}"/>
              </a:ext>
            </a:extLst>
          </p:cNvPr>
          <p:cNvSpPr/>
          <p:nvPr/>
        </p:nvSpPr>
        <p:spPr>
          <a:xfrm flipH="1">
            <a:off x="-1" y="595"/>
            <a:ext cx="7772400" cy="271961"/>
          </a:xfrm>
          <a:prstGeom prst="rect">
            <a:avLst/>
          </a:prstGeom>
          <a:gradFill flip="none" rotWithShape="1">
            <a:gsLst>
              <a:gs pos="2000">
                <a:srgbClr val="027CBA"/>
              </a:gs>
              <a:gs pos="94000">
                <a:schemeClr val="accent1">
                  <a:lumMod val="5000"/>
                  <a:lumOff val="95000"/>
                </a:schemeClr>
              </a:gs>
            </a:gsLst>
            <a:lin ang="10800000" scaled="0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/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b="1" kern="120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emplate Example</a:t>
            </a:r>
            <a:endParaRPr lang="en-US" sz="10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aphicFrame>
        <p:nvGraphicFramePr>
          <p:cNvPr id="49" name="Table 48">
            <a:extLst>
              <a:ext uri="{FF2B5EF4-FFF2-40B4-BE49-F238E27FC236}">
                <a16:creationId xmlns:a16="http://schemas.microsoft.com/office/drawing/2014/main" id="{92574808-9FEA-7B0C-99AD-35689BA2247E}"/>
              </a:ext>
            </a:extLst>
          </p:cNvPr>
          <p:cNvGraphicFramePr>
            <a:graphicFrameLocks noGrp="1"/>
          </p:cNvGraphicFramePr>
          <p:nvPr/>
        </p:nvGraphicFramePr>
        <p:xfrm>
          <a:off x="541338" y="1811336"/>
          <a:ext cx="6702425" cy="2822575"/>
        </p:xfrm>
        <a:graphic>
          <a:graphicData uri="http://schemas.openxmlformats.org/drawingml/2006/table">
            <a:tbl>
              <a:tblPr firstRow="1" firstCol="1" bandRow="1"/>
              <a:tblGrid>
                <a:gridCol w="2233248">
                  <a:extLst>
                    <a:ext uri="{9D8B030D-6E8A-4147-A177-3AD203B41FA5}">
                      <a16:colId xmlns:a16="http://schemas.microsoft.com/office/drawing/2014/main" val="3602462692"/>
                    </a:ext>
                  </a:extLst>
                </a:gridCol>
                <a:gridCol w="2068368">
                  <a:extLst>
                    <a:ext uri="{9D8B030D-6E8A-4147-A177-3AD203B41FA5}">
                      <a16:colId xmlns:a16="http://schemas.microsoft.com/office/drawing/2014/main" val="286214952"/>
                    </a:ext>
                  </a:extLst>
                </a:gridCol>
                <a:gridCol w="2400809">
                  <a:extLst>
                    <a:ext uri="{9D8B030D-6E8A-4147-A177-3AD203B41FA5}">
                      <a16:colId xmlns:a16="http://schemas.microsoft.com/office/drawing/2014/main" val="253329001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ymbo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m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unctio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14357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cess / Actio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presents a process or action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80923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rrow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hows relationships between the representative shapes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93736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amond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ymbolizes that a decision needs to be made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8474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ocumen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presents the input or output of a document, specificall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669152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put / Outpu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presents data that is available for input or output as well as representing resources used or generated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91610861"/>
                  </a:ext>
                </a:extLst>
              </a:tr>
            </a:tbl>
          </a:graphicData>
        </a:graphic>
      </p:graphicFrame>
      <p:sp>
        <p:nvSpPr>
          <p:cNvPr id="51" name="Rectangle 50">
            <a:extLst>
              <a:ext uri="{FF2B5EF4-FFF2-40B4-BE49-F238E27FC236}">
                <a16:creationId xmlns:a16="http://schemas.microsoft.com/office/drawing/2014/main" id="{4D54160F-852C-6A4B-ED2B-C29AFF46AE97}"/>
              </a:ext>
            </a:extLst>
          </p:cNvPr>
          <p:cNvSpPr/>
          <p:nvPr/>
        </p:nvSpPr>
        <p:spPr>
          <a:xfrm>
            <a:off x="1265238" y="2024555"/>
            <a:ext cx="812800" cy="4254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solidFill>
                <a:sysClr val="windowText" lastClr="000000"/>
              </a:solidFill>
            </a:endParaRPr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1307070F-5E23-D418-7ADD-FDC9A71C1A8D}"/>
              </a:ext>
            </a:extLst>
          </p:cNvPr>
          <p:cNvCxnSpPr/>
          <p:nvPr/>
        </p:nvCxnSpPr>
        <p:spPr>
          <a:xfrm>
            <a:off x="1169988" y="2765918"/>
            <a:ext cx="94615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Flowchart: Decision 54">
            <a:extLst>
              <a:ext uri="{FF2B5EF4-FFF2-40B4-BE49-F238E27FC236}">
                <a16:creationId xmlns:a16="http://schemas.microsoft.com/office/drawing/2014/main" id="{C4D6F9AD-6574-2B40-76CB-7E7BEB1AC837}"/>
              </a:ext>
            </a:extLst>
          </p:cNvPr>
          <p:cNvSpPr/>
          <p:nvPr/>
        </p:nvSpPr>
        <p:spPr>
          <a:xfrm>
            <a:off x="1406525" y="3054843"/>
            <a:ext cx="520700" cy="457200"/>
          </a:xfrm>
          <a:prstGeom prst="flowChartDecision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Flowchart: Document 55">
            <a:extLst>
              <a:ext uri="{FF2B5EF4-FFF2-40B4-BE49-F238E27FC236}">
                <a16:creationId xmlns:a16="http://schemas.microsoft.com/office/drawing/2014/main" id="{0292F8EC-02F0-61A2-2C5C-13DDF1F867AC}"/>
              </a:ext>
            </a:extLst>
          </p:cNvPr>
          <p:cNvSpPr/>
          <p:nvPr/>
        </p:nvSpPr>
        <p:spPr>
          <a:xfrm>
            <a:off x="1417638" y="3602909"/>
            <a:ext cx="520700" cy="450850"/>
          </a:xfrm>
          <a:prstGeom prst="flowChartDocumen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tIns="91440" rtlCol="0" anchor="t" anchorCtr="0"/>
          <a:lstStyle/>
          <a:p>
            <a:pPr algn="ctr"/>
            <a:endParaRPr lang="en-US" sz="1100">
              <a:solidFill>
                <a:sysClr val="windowText" lastClr="000000"/>
              </a:solidFill>
            </a:endParaRPr>
          </a:p>
        </p:txBody>
      </p:sp>
      <p:sp>
        <p:nvSpPr>
          <p:cNvPr id="58" name="Flowchart: Data 57">
            <a:extLst>
              <a:ext uri="{FF2B5EF4-FFF2-40B4-BE49-F238E27FC236}">
                <a16:creationId xmlns:a16="http://schemas.microsoft.com/office/drawing/2014/main" id="{C41B943D-216D-57B3-46ED-519B4AA03D0A}"/>
              </a:ext>
            </a:extLst>
          </p:cNvPr>
          <p:cNvSpPr/>
          <p:nvPr/>
        </p:nvSpPr>
        <p:spPr>
          <a:xfrm>
            <a:off x="1214437" y="4163295"/>
            <a:ext cx="904875" cy="371475"/>
          </a:xfrm>
          <a:prstGeom prst="flowChartInputOutpu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solidFill>
                <a:sysClr val="windowText" lastClr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861459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0867c8d-1cc9-4acd-a073-94634f6a764f" xsi:nil="true"/>
    <lcf76f155ced4ddcb4097134ff3c332f xmlns="bc6fc9a0-8cf0-435b-a5c3-787b2fe5bedd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D24004269783F4484DD1848A00DFD3B" ma:contentTypeVersion="14" ma:contentTypeDescription="Create a new document." ma:contentTypeScope="" ma:versionID="949d91f85b0396c07df2e601f29e3eab">
  <xsd:schema xmlns:xsd="http://www.w3.org/2001/XMLSchema" xmlns:xs="http://www.w3.org/2001/XMLSchema" xmlns:p="http://schemas.microsoft.com/office/2006/metadata/properties" xmlns:ns2="bc6fc9a0-8cf0-435b-a5c3-787b2fe5bedd" xmlns:ns3="20867c8d-1cc9-4acd-a073-94634f6a764f" targetNamespace="http://schemas.microsoft.com/office/2006/metadata/properties" ma:root="true" ma:fieldsID="9dc925c5a342fbd71a3badc790b9c820" ns2:_="" ns3:_="">
    <xsd:import namespace="bc6fc9a0-8cf0-435b-a5c3-787b2fe5bedd"/>
    <xsd:import namespace="20867c8d-1cc9-4acd-a073-94634f6a764f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SearchProperties" minOccurs="0"/>
                <xsd:element ref="ns2:MediaLengthInSecond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c6fc9a0-8cf0-435b-a5c3-787b2fe5bed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79cf906e-e933-44a8-8421-1c91ada6f122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9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1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0867c8d-1cc9-4acd-a073-94634f6a764f" elementFormDefault="qualified">
    <xsd:import namespace="http://schemas.microsoft.com/office/2006/documentManagement/types"/>
    <xsd:import namespace="http://schemas.microsoft.com/office/infopath/2007/PartnerControls"/>
    <xsd:element name="TaxCatchAll" ma:index="17" nillable="true" ma:displayName="Taxonomy Catch All Column" ma:hidden="true" ma:list="{bf2d2cf4-37d0-44af-aad9-3d314cc6947a}" ma:internalName="TaxCatchAll" ma:showField="CatchAllData" ma:web="7467b07a-63e4-4526-818f-48c6a4d2dc7d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3028C082-5252-4DB6-A2C5-44EE28293CB6}">
  <ds:schemaRefs>
    <ds:schemaRef ds:uri="bc6fc9a0-8cf0-435b-a5c3-787b2fe5bedd"/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20867c8d-1cc9-4acd-a073-94634f6a764f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8EADA044-D78F-45A6-A637-B9591E96BA6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5A6F0437-CEDA-4923-B330-277950407B3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c6fc9a0-8cf0-435b-a5c3-787b2fe5bedd"/>
    <ds:schemaRef ds:uri="20867c8d-1cc9-4acd-a073-94634f6a764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Metadata/LabelInfo.xml><?xml version="1.0" encoding="utf-8"?>
<clbl:labelList xmlns:clbl="http://schemas.microsoft.com/office/2020/mipLabelMetadata">
  <clbl:label id="{7d2fdb41-339c-4257-87f2-a665730b31fc}" enabled="0" method="" siteId="{7d2fdb41-339c-4257-87f2-a665730b31fc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02</TotalTime>
  <Words>223</Words>
  <Application>Microsoft Office PowerPoint</Application>
  <PresentationFormat>Custom</PresentationFormat>
  <Paragraphs>7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Fox, Elizabeth</cp:lastModifiedBy>
  <cp:revision>2</cp:revision>
  <dcterms:created xsi:type="dcterms:W3CDTF">2025-03-18T14:31:12Z</dcterms:created>
  <dcterms:modified xsi:type="dcterms:W3CDTF">2025-03-19T15:35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D24004269783F4484DD1848A00DFD3B</vt:lpwstr>
  </property>
  <property fmtid="{D5CDD505-2E9C-101B-9397-08002B2CF9AE}" pid="3" name="MediaServiceImageTags">
    <vt:lpwstr/>
  </property>
</Properties>
</file>